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Slides/notesSlide1.xml" ContentType="application/vnd.openxmlformats-officedocument.presentationml.notesSlide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olors3.xml" ContentType="application/vnd.ms-office.chartcolorstyle+xml"/>
  <Override PartName="/ppt/charts/style3.xml" ContentType="application/vnd.ms-office.chart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theme/themeOverride3.xml" ContentType="application/vnd.openxmlformats-officedocument.themeOverride+xml"/>
  <Override PartName="/ppt/authors.xml" ContentType="application/vnd.ms-powerpoint.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42976800" cy="21031200"/>
  <p:notesSz cx="6858000" cy="9144000"/>
  <p:defaultTextStyle>
    <a:defPPr>
      <a:defRPr lang="en-US"/>
    </a:defPPr>
    <a:lvl1pPr marL="0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1pPr>
    <a:lvl2pPr marL="1725752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2pPr>
    <a:lvl3pPr marL="3451494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3pPr>
    <a:lvl4pPr marL="5177232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4pPr>
    <a:lvl5pPr marL="6902980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5pPr>
    <a:lvl6pPr marL="8628722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6pPr>
    <a:lvl7pPr marL="10354467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7pPr>
    <a:lvl8pPr marL="12080203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8pPr>
    <a:lvl9pPr marL="13805951" algn="l" defTabSz="1725752" rtl="0" eaLnBrk="1" latinLnBrk="0" hangingPunct="1">
      <a:defRPr sz="679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6E418698-2B46-D64C-BE3A-D5F938577802}">
          <p14:sldIdLst>
            <p14:sldId id="25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2806" userDrawn="1">
          <p15:clr>
            <a:srgbClr val="A4A3A4"/>
          </p15:clr>
        </p15:guide>
        <p15:guide id="2" pos="14972" userDrawn="1">
          <p15:clr>
            <a:srgbClr val="A4A3A4"/>
          </p15:clr>
        </p15:guide>
        <p15:guide id="4" pos="20919" userDrawn="1">
          <p15:clr>
            <a:srgbClr val="A4A3A4"/>
          </p15:clr>
        </p15:guide>
        <p15:guide id="5" orient="horz" pos="3186" userDrawn="1">
          <p15:clr>
            <a:srgbClr val="A4A3A4"/>
          </p15:clr>
        </p15:guide>
        <p15:guide id="6" pos="9106" userDrawn="1">
          <p15:clr>
            <a:srgbClr val="A4A3A4"/>
          </p15:clr>
        </p15:guide>
        <p15:guide id="7" pos="26662" userDrawn="1">
          <p15:clr>
            <a:srgbClr val="A4A3A4"/>
          </p15:clr>
        </p15:guide>
        <p15:guide id="8" orient="horz" pos="40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0BBC22A-8975-858A-8CEE-7FAA4A476EA4}" name="Kathryn Wall" initials="KW" userId="2033b81b90bf8706" providerId="Windows Live"/>
  <p188:author id="{25C8694C-FD4D-092D-6F30-63278403EEE1}" name="Francie Moehring" initials="FM" userId="a26e7d79b877ebc5" providerId="Windows Live"/>
  <p188:author id="{F2C18F4C-638A-2FD0-593A-762D53EE95C3}" name="Apeksha Shenoy" initials="AS" userId="Apeksha Shenoy" providerId="None"/>
  <p188:author id="{EC7D255E-8778-E4D6-4019-C141D1260A4B}" name="Tracey Fine" initials="TF" userId="S::tracey.fine@apellis.com::61e17084-8757-4b1e-98ae-02c1863e3715" providerId="AD"/>
  <p188:author id="{635DD0C8-1507-75DA-59F3-83C4C72FC93D}" name="Laura Lim" initials="LL" userId="d38d004d217e9a46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B5D76"/>
    <a:srgbClr val="2C5E76"/>
    <a:srgbClr val="6099B0"/>
    <a:srgbClr val="339193"/>
    <a:srgbClr val="009193"/>
    <a:srgbClr val="FF9E6D"/>
    <a:srgbClr val="FF681D"/>
    <a:srgbClr val="005D83"/>
    <a:srgbClr val="50D6D4"/>
    <a:srgbClr val="73FD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435DA40-34A1-8E49-B4ED-14C56E2CF1E8}" v="3" dt="2022-07-18T15:14:45.52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82" autoAdjust="0"/>
    <p:restoredTop sz="96327"/>
  </p:normalViewPr>
  <p:slideViewPr>
    <p:cSldViewPr snapToObjects="1">
      <p:cViewPr varScale="1">
        <p:scale>
          <a:sx n="25" d="100"/>
          <a:sy n="25" d="100"/>
        </p:scale>
        <p:origin x="79" y="435"/>
      </p:cViewPr>
      <p:guideLst>
        <p:guide orient="horz" pos="12806"/>
        <p:guide pos="14972"/>
        <p:guide pos="20919"/>
        <p:guide orient="horz" pos="3186"/>
        <p:guide pos="9106"/>
        <p:guide pos="26662"/>
        <p:guide orient="horz" pos="40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11" Type="http://schemas.openxmlformats.org/officeDocument/2006/relationships/customXml" Target="../customXml/item2.xml"/><Relationship Id="rId5" Type="http://schemas.openxmlformats.org/officeDocument/2006/relationships/viewProps" Target="viewProps.xml"/><Relationship Id="rId10" Type="http://schemas.openxmlformats.org/officeDocument/2006/relationships/customXml" Target="../customXml/item1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089178298129349"/>
          <c:y val="2.475237437638457E-2"/>
          <c:w val="0.81801138556466835"/>
          <c:h val="0.81218405150277029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3.0356486188095333E-2"/>
                  <c:y val="-7.246515093094231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57E2-43FC-AE09-49E319271691}"/>
                </c:ext>
              </c:extLst>
            </c:dLbl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800" b="1" i="0" u="none" strike="noStrike" kern="1200" baseline="0">
                    <a:solidFill>
                      <a:srgbClr val="005D83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Week 16</c:v>
                </c:pt>
                <c:pt idx="1">
                  <c:v>Baseline</c:v>
                </c:pt>
                <c:pt idx="2">
                  <c:v>Week 16</c:v>
                </c:pt>
                <c:pt idx="3">
                  <c:v>Baseline</c:v>
                </c:pt>
                <c:pt idx="4">
                  <c:v>Week 16</c:v>
                </c:pt>
                <c:pt idx="5">
                  <c:v>Baseline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100</c:v>
                </c:pt>
                <c:pt idx="1">
                  <c:v>0</c:v>
                </c:pt>
                <c:pt idx="2">
                  <c:v>60</c:v>
                </c:pt>
                <c:pt idx="3">
                  <c:v>0</c:v>
                </c:pt>
                <c:pt idx="4">
                  <c:v>77.8</c:v>
                </c:pt>
                <c:pt idx="5">
                  <c:v>44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E2-43FC-AE09-49E319271691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461830704"/>
        <c:axId val="953533520"/>
      </c:barChart>
      <c:catAx>
        <c:axId val="461830704"/>
        <c:scaling>
          <c:orientation val="minMax"/>
        </c:scaling>
        <c:delete val="0"/>
        <c:axPos val="l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rgbClr val="EFF1F0">
                <a:lumMod val="10000"/>
              </a:srgb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3533520"/>
        <c:crosses val="autoZero"/>
        <c:auto val="1"/>
        <c:lblAlgn val="ctr"/>
        <c:lblOffset val="100"/>
        <c:noMultiLvlLbl val="0"/>
      </c:catAx>
      <c:valAx>
        <c:axId val="953533520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8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24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tients (%) with Normalized LDH</a:t>
                </a:r>
              </a:p>
            </c:rich>
          </c:tx>
          <c:layout>
            <c:manualLayout>
              <c:xMode val="edge"/>
              <c:yMode val="edge"/>
              <c:x val="0.25244206392805552"/>
              <c:y val="0.903787166529556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28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out"/>
        <c:tickLblPos val="nextTo"/>
        <c:spPr>
          <a:noFill/>
          <a:ln>
            <a:solidFill>
              <a:srgbClr val="EFF1F0">
                <a:lumMod val="10000"/>
              </a:srgb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61830704"/>
        <c:crosses val="autoZero"/>
        <c:crossBetween val="between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582547437807129"/>
          <c:y val="2.5204736614110792E-2"/>
          <c:w val="0.80945588972429316"/>
          <c:h val="0.8153449034561161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800" b="1" i="0" u="none" strike="noStrike" kern="1200" baseline="0">
                    <a:solidFill>
                      <a:srgbClr val="005D83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Week 16</c:v>
                </c:pt>
                <c:pt idx="1">
                  <c:v>Baseline</c:v>
                </c:pt>
                <c:pt idx="2">
                  <c:v>Week 16</c:v>
                </c:pt>
                <c:pt idx="3">
                  <c:v>Baseline</c:v>
                </c:pt>
                <c:pt idx="4">
                  <c:v>Week 16</c:v>
                </c:pt>
                <c:pt idx="5">
                  <c:v>Baseline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75</c:v>
                </c:pt>
                <c:pt idx="1">
                  <c:v>0</c:v>
                </c:pt>
                <c:pt idx="2">
                  <c:v>80</c:v>
                </c:pt>
                <c:pt idx="3">
                  <c:v>0</c:v>
                </c:pt>
                <c:pt idx="4">
                  <c:v>88.9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D2-4E93-8A2F-01D7D0349C89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461830704"/>
        <c:axId val="953533520"/>
      </c:barChart>
      <c:catAx>
        <c:axId val="461830704"/>
        <c:scaling>
          <c:orientation val="minMax"/>
        </c:scaling>
        <c:delete val="0"/>
        <c:axPos val="l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rgbClr val="EFF1F0">
                <a:lumMod val="10000"/>
              </a:srgb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3533520"/>
        <c:crosses val="autoZero"/>
        <c:auto val="1"/>
        <c:lblAlgn val="ctr"/>
        <c:lblOffset val="100"/>
        <c:noMultiLvlLbl val="0"/>
      </c:catAx>
      <c:valAx>
        <c:axId val="953533520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8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24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tients (%) with Normalized ARC</a:t>
                </a:r>
              </a:p>
            </c:rich>
          </c:tx>
          <c:layout>
            <c:manualLayout>
              <c:xMode val="edge"/>
              <c:yMode val="edge"/>
              <c:x val="0.24049395715070504"/>
              <c:y val="0.912709908462934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28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out"/>
        <c:tickLblPos val="nextTo"/>
        <c:spPr>
          <a:noFill/>
          <a:ln>
            <a:solidFill>
              <a:srgbClr val="EFF1F0">
                <a:lumMod val="10000"/>
              </a:srgb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61830704"/>
        <c:crosses val="autoZero"/>
        <c:crossBetween val="between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871093659339156"/>
          <c:y val="2.3145501869699273E-2"/>
          <c:w val="0.7937137347774057"/>
          <c:h val="0.78026613359731567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800" b="1" i="0" u="none" strike="noStrike" kern="1200" baseline="0">
                    <a:solidFill>
                      <a:srgbClr val="005D83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Week 16</c:v>
                </c:pt>
                <c:pt idx="1">
                  <c:v>Baseline</c:v>
                </c:pt>
                <c:pt idx="2">
                  <c:v>Week 16</c:v>
                </c:pt>
                <c:pt idx="3">
                  <c:v>Baseline</c:v>
                </c:pt>
                <c:pt idx="4">
                  <c:v>Week 16</c:v>
                </c:pt>
                <c:pt idx="5">
                  <c:v>Baseline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75</c:v>
                </c:pt>
                <c:pt idx="1">
                  <c:v>25</c:v>
                </c:pt>
                <c:pt idx="2">
                  <c:v>60</c:v>
                </c:pt>
                <c:pt idx="3">
                  <c:v>20</c:v>
                </c:pt>
                <c:pt idx="4">
                  <c:v>22.2</c:v>
                </c:pt>
                <c:pt idx="5">
                  <c:v>11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51-4841-B5D2-ABCA66702DE0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461830704"/>
        <c:axId val="953533520"/>
      </c:barChart>
      <c:catAx>
        <c:axId val="461830704"/>
        <c:scaling>
          <c:orientation val="minMax"/>
        </c:scaling>
        <c:delete val="0"/>
        <c:axPos val="l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rgbClr val="EFF1F0">
                <a:lumMod val="10000"/>
              </a:srgb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3533520"/>
        <c:crosses val="autoZero"/>
        <c:auto val="1"/>
        <c:lblAlgn val="ctr"/>
        <c:lblOffset val="100"/>
        <c:noMultiLvlLbl val="0"/>
      </c:catAx>
      <c:valAx>
        <c:axId val="953533520"/>
        <c:scaling>
          <c:orientation val="minMax"/>
          <c:max val="100"/>
        </c:scaling>
        <c:delete val="0"/>
        <c:axPos val="b"/>
        <c:numFmt formatCode="#,##0" sourceLinked="0"/>
        <c:majorTickMark val="out"/>
        <c:minorTickMark val="out"/>
        <c:tickLblPos val="nextTo"/>
        <c:spPr>
          <a:noFill/>
          <a:ln>
            <a:solidFill>
              <a:srgbClr val="EFF1F0">
                <a:lumMod val="10000"/>
              </a:srgb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61830704"/>
        <c:crosses val="autoZero"/>
        <c:crossBetween val="between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47668927887681"/>
          <c:y val="2.5125261552258033E-3"/>
          <c:w val="0.80879262679257424"/>
          <c:h val="0.819971313348178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800" b="1" i="0" u="none" strike="noStrike" kern="1200" baseline="0">
                    <a:solidFill>
                      <a:srgbClr val="005D83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Week 16</c:v>
                </c:pt>
                <c:pt idx="1">
                  <c:v>Baseline</c:v>
                </c:pt>
                <c:pt idx="2">
                  <c:v>Week 16</c:v>
                </c:pt>
                <c:pt idx="3">
                  <c:v>Baseline</c:v>
                </c:pt>
                <c:pt idx="4">
                  <c:v>Week 16</c:v>
                </c:pt>
                <c:pt idx="5">
                  <c:v>Baseline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62.5</c:v>
                </c:pt>
                <c:pt idx="1">
                  <c:v>12.5</c:v>
                </c:pt>
                <c:pt idx="2">
                  <c:v>40</c:v>
                </c:pt>
                <c:pt idx="3">
                  <c:v>0</c:v>
                </c:pt>
                <c:pt idx="4">
                  <c:v>66.7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C7-4DED-897A-BB30B451E1E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461830704"/>
        <c:axId val="953533520"/>
      </c:barChart>
      <c:catAx>
        <c:axId val="461830704"/>
        <c:scaling>
          <c:orientation val="minMax"/>
        </c:scaling>
        <c:delete val="0"/>
        <c:axPos val="l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rgbClr val="EFF1F0">
                <a:lumMod val="10000"/>
              </a:srgb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3533520"/>
        <c:crosses val="autoZero"/>
        <c:auto val="1"/>
        <c:lblAlgn val="ctr"/>
        <c:lblOffset val="100"/>
        <c:noMultiLvlLbl val="0"/>
      </c:catAx>
      <c:valAx>
        <c:axId val="953533520"/>
        <c:scaling>
          <c:orientation val="minMax"/>
          <c:max val="100"/>
        </c:scaling>
        <c:delete val="0"/>
        <c:axPos val="b"/>
        <c:numFmt formatCode="#,##0" sourceLinked="0"/>
        <c:majorTickMark val="out"/>
        <c:minorTickMark val="out"/>
        <c:tickLblPos val="nextTo"/>
        <c:spPr>
          <a:noFill/>
          <a:ln>
            <a:solidFill>
              <a:srgbClr val="EFF1F0">
                <a:lumMod val="10000"/>
              </a:srgb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61830704"/>
        <c:crosses val="autoZero"/>
        <c:crossBetween val="between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ADB97D-3F9F-B146-8292-2543B7F11817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6225" y="1143000"/>
            <a:ext cx="6305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8F3B8F-24A4-864B-B505-FAEAF33EE1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513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1pPr>
    <a:lvl2pPr marL="355564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2pPr>
    <a:lvl3pPr marL="711129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3pPr>
    <a:lvl4pPr marL="1066693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4pPr>
    <a:lvl5pPr marL="1422258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5pPr>
    <a:lvl6pPr marL="1777822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6pPr>
    <a:lvl7pPr marL="2133387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7pPr>
    <a:lvl8pPr marL="2488951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8pPr>
    <a:lvl9pPr marL="2844516" algn="l" defTabSz="711129" rtl="0" eaLnBrk="1" latinLnBrk="0" hangingPunct="1">
      <a:defRPr sz="93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76225" y="1143000"/>
            <a:ext cx="63055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8F3B8F-24A4-864B-B505-FAEAF33EE12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855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23263" y="3441918"/>
            <a:ext cx="36530280" cy="7321973"/>
          </a:xfrm>
        </p:spPr>
        <p:txBody>
          <a:bodyPr anchor="b"/>
          <a:lstStyle>
            <a:lvl1pPr algn="ctr">
              <a:defRPr sz="114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372103" y="11046254"/>
            <a:ext cx="32232600" cy="5077670"/>
          </a:xfrm>
        </p:spPr>
        <p:txBody>
          <a:bodyPr/>
          <a:lstStyle>
            <a:lvl1pPr marL="0" indent="0" algn="ctr">
              <a:buNone/>
              <a:defRPr sz="4568"/>
            </a:lvl1pPr>
            <a:lvl2pPr marL="870318" indent="0" algn="ctr">
              <a:buNone/>
              <a:defRPr sz="3809"/>
            </a:lvl2pPr>
            <a:lvl3pPr marL="1740640" indent="0" algn="ctr">
              <a:buNone/>
              <a:defRPr sz="3426"/>
            </a:lvl3pPr>
            <a:lvl4pPr marL="2610961" indent="0" algn="ctr">
              <a:buNone/>
              <a:defRPr sz="3047"/>
            </a:lvl4pPr>
            <a:lvl5pPr marL="3481282" indent="0" algn="ctr">
              <a:buNone/>
              <a:defRPr sz="3047"/>
            </a:lvl5pPr>
            <a:lvl6pPr marL="4351603" indent="0" algn="ctr">
              <a:buNone/>
              <a:defRPr sz="3047"/>
            </a:lvl6pPr>
            <a:lvl7pPr marL="5221921" indent="0" algn="ctr">
              <a:buNone/>
              <a:defRPr sz="3047"/>
            </a:lvl7pPr>
            <a:lvl8pPr marL="6092245" indent="0" algn="ctr">
              <a:buNone/>
              <a:defRPr sz="3047"/>
            </a:lvl8pPr>
            <a:lvl9pPr marL="6962563" indent="0" algn="ctr">
              <a:buNone/>
              <a:defRPr sz="304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477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095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755284" y="1119721"/>
            <a:ext cx="9266873" cy="17822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54658" y="1119721"/>
            <a:ext cx="27263408" cy="17822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392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048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32274" y="5243210"/>
            <a:ext cx="37067490" cy="8748394"/>
          </a:xfrm>
        </p:spPr>
        <p:txBody>
          <a:bodyPr anchor="b"/>
          <a:lstStyle>
            <a:lvl1pPr>
              <a:defRPr sz="114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32274" y="14074369"/>
            <a:ext cx="37067490" cy="4600574"/>
          </a:xfrm>
        </p:spPr>
        <p:txBody>
          <a:bodyPr/>
          <a:lstStyle>
            <a:lvl1pPr marL="0" indent="0">
              <a:buNone/>
              <a:defRPr sz="4568">
                <a:solidFill>
                  <a:schemeClr val="tx1"/>
                </a:solidFill>
              </a:defRPr>
            </a:lvl1pPr>
            <a:lvl2pPr marL="870318" indent="0">
              <a:buNone/>
              <a:defRPr sz="3809">
                <a:solidFill>
                  <a:schemeClr val="tx1">
                    <a:tint val="75000"/>
                  </a:schemeClr>
                </a:solidFill>
              </a:defRPr>
            </a:lvl2pPr>
            <a:lvl3pPr marL="1740640" indent="0">
              <a:buNone/>
              <a:defRPr sz="3426">
                <a:solidFill>
                  <a:schemeClr val="tx1">
                    <a:tint val="75000"/>
                  </a:schemeClr>
                </a:solidFill>
              </a:defRPr>
            </a:lvl3pPr>
            <a:lvl4pPr marL="2610961" indent="0">
              <a:buNone/>
              <a:defRPr sz="3047">
                <a:solidFill>
                  <a:schemeClr val="tx1">
                    <a:tint val="75000"/>
                  </a:schemeClr>
                </a:solidFill>
              </a:defRPr>
            </a:lvl4pPr>
            <a:lvl5pPr marL="3481282" indent="0">
              <a:buNone/>
              <a:defRPr sz="3047">
                <a:solidFill>
                  <a:schemeClr val="tx1">
                    <a:tint val="75000"/>
                  </a:schemeClr>
                </a:solidFill>
              </a:defRPr>
            </a:lvl5pPr>
            <a:lvl6pPr marL="4351603" indent="0">
              <a:buNone/>
              <a:defRPr sz="3047">
                <a:solidFill>
                  <a:schemeClr val="tx1">
                    <a:tint val="75000"/>
                  </a:schemeClr>
                </a:solidFill>
              </a:defRPr>
            </a:lvl6pPr>
            <a:lvl7pPr marL="5221921" indent="0">
              <a:buNone/>
              <a:defRPr sz="3047">
                <a:solidFill>
                  <a:schemeClr val="tx1">
                    <a:tint val="75000"/>
                  </a:schemeClr>
                </a:solidFill>
              </a:defRPr>
            </a:lvl7pPr>
            <a:lvl8pPr marL="6092245" indent="0">
              <a:buNone/>
              <a:defRPr sz="3047">
                <a:solidFill>
                  <a:schemeClr val="tx1">
                    <a:tint val="75000"/>
                  </a:schemeClr>
                </a:solidFill>
              </a:defRPr>
            </a:lvl8pPr>
            <a:lvl9pPr marL="6962563" indent="0">
              <a:buNone/>
              <a:defRPr sz="30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6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54655" y="5598585"/>
            <a:ext cx="18265140" cy="133441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757005" y="5598585"/>
            <a:ext cx="18265140" cy="133441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783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60253" y="1119728"/>
            <a:ext cx="37067490" cy="406506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60267" y="5155572"/>
            <a:ext cx="18181199" cy="2526664"/>
          </a:xfrm>
        </p:spPr>
        <p:txBody>
          <a:bodyPr anchor="b"/>
          <a:lstStyle>
            <a:lvl1pPr marL="0" indent="0">
              <a:buNone/>
              <a:defRPr sz="4568" b="1"/>
            </a:lvl1pPr>
            <a:lvl2pPr marL="870318" indent="0">
              <a:buNone/>
              <a:defRPr sz="3809" b="1"/>
            </a:lvl2pPr>
            <a:lvl3pPr marL="1740640" indent="0">
              <a:buNone/>
              <a:defRPr sz="3426" b="1"/>
            </a:lvl3pPr>
            <a:lvl4pPr marL="2610961" indent="0">
              <a:buNone/>
              <a:defRPr sz="3047" b="1"/>
            </a:lvl4pPr>
            <a:lvl5pPr marL="3481282" indent="0">
              <a:buNone/>
              <a:defRPr sz="3047" b="1"/>
            </a:lvl5pPr>
            <a:lvl6pPr marL="4351603" indent="0">
              <a:buNone/>
              <a:defRPr sz="3047" b="1"/>
            </a:lvl6pPr>
            <a:lvl7pPr marL="5221921" indent="0">
              <a:buNone/>
              <a:defRPr sz="3047" b="1"/>
            </a:lvl7pPr>
            <a:lvl8pPr marL="6092245" indent="0">
              <a:buNone/>
              <a:defRPr sz="3047" b="1"/>
            </a:lvl8pPr>
            <a:lvl9pPr marL="6962563" indent="0">
              <a:buNone/>
              <a:defRPr sz="30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60267" y="7682238"/>
            <a:ext cx="18181199" cy="112994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757012" y="5155572"/>
            <a:ext cx="18270738" cy="2526664"/>
          </a:xfrm>
        </p:spPr>
        <p:txBody>
          <a:bodyPr anchor="b"/>
          <a:lstStyle>
            <a:lvl1pPr marL="0" indent="0">
              <a:buNone/>
              <a:defRPr sz="4568" b="1"/>
            </a:lvl1pPr>
            <a:lvl2pPr marL="870318" indent="0">
              <a:buNone/>
              <a:defRPr sz="3809" b="1"/>
            </a:lvl2pPr>
            <a:lvl3pPr marL="1740640" indent="0">
              <a:buNone/>
              <a:defRPr sz="3426" b="1"/>
            </a:lvl3pPr>
            <a:lvl4pPr marL="2610961" indent="0">
              <a:buNone/>
              <a:defRPr sz="3047" b="1"/>
            </a:lvl4pPr>
            <a:lvl5pPr marL="3481282" indent="0">
              <a:buNone/>
              <a:defRPr sz="3047" b="1"/>
            </a:lvl5pPr>
            <a:lvl6pPr marL="4351603" indent="0">
              <a:buNone/>
              <a:defRPr sz="3047" b="1"/>
            </a:lvl6pPr>
            <a:lvl7pPr marL="5221921" indent="0">
              <a:buNone/>
              <a:defRPr sz="3047" b="1"/>
            </a:lvl7pPr>
            <a:lvl8pPr marL="6092245" indent="0">
              <a:buNone/>
              <a:defRPr sz="3047" b="1"/>
            </a:lvl8pPr>
            <a:lvl9pPr marL="6962563" indent="0">
              <a:buNone/>
              <a:defRPr sz="30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757012" y="7682238"/>
            <a:ext cx="18270738" cy="112994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657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673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281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60262" y="1402080"/>
            <a:ext cx="13861136" cy="4907280"/>
          </a:xfrm>
        </p:spPr>
        <p:txBody>
          <a:bodyPr anchor="b"/>
          <a:lstStyle>
            <a:lvl1pPr>
              <a:defRPr sz="609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270746" y="3028115"/>
            <a:ext cx="21757005" cy="14945783"/>
          </a:xfrm>
        </p:spPr>
        <p:txBody>
          <a:bodyPr/>
          <a:lstStyle>
            <a:lvl1pPr>
              <a:defRPr sz="6091"/>
            </a:lvl1pPr>
            <a:lvl2pPr>
              <a:defRPr sz="5332"/>
            </a:lvl2pPr>
            <a:lvl3pPr>
              <a:defRPr sz="4568"/>
            </a:lvl3pPr>
            <a:lvl4pPr>
              <a:defRPr sz="3809"/>
            </a:lvl4pPr>
            <a:lvl5pPr>
              <a:defRPr sz="3809"/>
            </a:lvl5pPr>
            <a:lvl6pPr>
              <a:defRPr sz="3809"/>
            </a:lvl6pPr>
            <a:lvl7pPr>
              <a:defRPr sz="3809"/>
            </a:lvl7pPr>
            <a:lvl8pPr>
              <a:defRPr sz="3809"/>
            </a:lvl8pPr>
            <a:lvl9pPr>
              <a:defRPr sz="38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60262" y="6309362"/>
            <a:ext cx="13861136" cy="11688870"/>
          </a:xfrm>
        </p:spPr>
        <p:txBody>
          <a:bodyPr/>
          <a:lstStyle>
            <a:lvl1pPr marL="0" indent="0">
              <a:buNone/>
              <a:defRPr sz="3047"/>
            </a:lvl1pPr>
            <a:lvl2pPr marL="870318" indent="0">
              <a:buNone/>
              <a:defRPr sz="2665"/>
            </a:lvl2pPr>
            <a:lvl3pPr marL="1740640" indent="0">
              <a:buNone/>
              <a:defRPr sz="2285"/>
            </a:lvl3pPr>
            <a:lvl4pPr marL="2610961" indent="0">
              <a:buNone/>
              <a:defRPr sz="1903"/>
            </a:lvl4pPr>
            <a:lvl5pPr marL="3481282" indent="0">
              <a:buNone/>
              <a:defRPr sz="1903"/>
            </a:lvl5pPr>
            <a:lvl6pPr marL="4351603" indent="0">
              <a:buNone/>
              <a:defRPr sz="1903"/>
            </a:lvl6pPr>
            <a:lvl7pPr marL="5221921" indent="0">
              <a:buNone/>
              <a:defRPr sz="1903"/>
            </a:lvl7pPr>
            <a:lvl8pPr marL="6092245" indent="0">
              <a:buNone/>
              <a:defRPr sz="1903"/>
            </a:lvl8pPr>
            <a:lvl9pPr marL="6962563" indent="0">
              <a:buNone/>
              <a:defRPr sz="1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542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60262" y="1402080"/>
            <a:ext cx="13861136" cy="4907280"/>
          </a:xfrm>
        </p:spPr>
        <p:txBody>
          <a:bodyPr anchor="b"/>
          <a:lstStyle>
            <a:lvl1pPr>
              <a:defRPr sz="609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270746" y="3028115"/>
            <a:ext cx="21757005" cy="14945783"/>
          </a:xfrm>
        </p:spPr>
        <p:txBody>
          <a:bodyPr anchor="t"/>
          <a:lstStyle>
            <a:lvl1pPr marL="0" indent="0">
              <a:buNone/>
              <a:defRPr sz="6091"/>
            </a:lvl1pPr>
            <a:lvl2pPr marL="870318" indent="0">
              <a:buNone/>
              <a:defRPr sz="5332"/>
            </a:lvl2pPr>
            <a:lvl3pPr marL="1740640" indent="0">
              <a:buNone/>
              <a:defRPr sz="4568"/>
            </a:lvl3pPr>
            <a:lvl4pPr marL="2610961" indent="0">
              <a:buNone/>
              <a:defRPr sz="3809"/>
            </a:lvl4pPr>
            <a:lvl5pPr marL="3481282" indent="0">
              <a:buNone/>
              <a:defRPr sz="3809"/>
            </a:lvl5pPr>
            <a:lvl6pPr marL="4351603" indent="0">
              <a:buNone/>
              <a:defRPr sz="3809"/>
            </a:lvl6pPr>
            <a:lvl7pPr marL="5221921" indent="0">
              <a:buNone/>
              <a:defRPr sz="3809"/>
            </a:lvl7pPr>
            <a:lvl8pPr marL="6092245" indent="0">
              <a:buNone/>
              <a:defRPr sz="3809"/>
            </a:lvl8pPr>
            <a:lvl9pPr marL="6962563" indent="0">
              <a:buNone/>
              <a:defRPr sz="380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60262" y="6309362"/>
            <a:ext cx="13861136" cy="11688870"/>
          </a:xfrm>
        </p:spPr>
        <p:txBody>
          <a:bodyPr/>
          <a:lstStyle>
            <a:lvl1pPr marL="0" indent="0">
              <a:buNone/>
              <a:defRPr sz="3047"/>
            </a:lvl1pPr>
            <a:lvl2pPr marL="870318" indent="0">
              <a:buNone/>
              <a:defRPr sz="2665"/>
            </a:lvl2pPr>
            <a:lvl3pPr marL="1740640" indent="0">
              <a:buNone/>
              <a:defRPr sz="2285"/>
            </a:lvl3pPr>
            <a:lvl4pPr marL="2610961" indent="0">
              <a:buNone/>
              <a:defRPr sz="1903"/>
            </a:lvl4pPr>
            <a:lvl5pPr marL="3481282" indent="0">
              <a:buNone/>
              <a:defRPr sz="1903"/>
            </a:lvl5pPr>
            <a:lvl6pPr marL="4351603" indent="0">
              <a:buNone/>
              <a:defRPr sz="1903"/>
            </a:lvl6pPr>
            <a:lvl7pPr marL="5221921" indent="0">
              <a:buNone/>
              <a:defRPr sz="1903"/>
            </a:lvl7pPr>
            <a:lvl8pPr marL="6092245" indent="0">
              <a:buNone/>
              <a:defRPr sz="1903"/>
            </a:lvl8pPr>
            <a:lvl9pPr marL="6962563" indent="0">
              <a:buNone/>
              <a:defRPr sz="1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288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54655" y="1119728"/>
            <a:ext cx="37067490" cy="40650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54655" y="5598585"/>
            <a:ext cx="37067490" cy="133441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54655" y="19492818"/>
            <a:ext cx="966978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238896-5B48-B341-85F3-F094531D6F5A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236065" y="19492818"/>
            <a:ext cx="1450467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352365" y="19492818"/>
            <a:ext cx="966978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30FA3-830D-2647-9FA0-5A076E88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270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740640" rtl="0" eaLnBrk="1" latinLnBrk="0" hangingPunct="1">
        <a:lnSpc>
          <a:spcPct val="90000"/>
        </a:lnSpc>
        <a:spcBef>
          <a:spcPct val="0"/>
        </a:spcBef>
        <a:buNone/>
        <a:defRPr sz="8375" kern="1200">
          <a:solidFill>
            <a:schemeClr val="tx1">
              <a:lumMod val="10000"/>
            </a:schemeClr>
          </a:solidFill>
          <a:latin typeface="+mj-lt"/>
          <a:ea typeface="+mj-ea"/>
          <a:cs typeface="+mj-cs"/>
        </a:defRPr>
      </a:lvl1pPr>
    </p:titleStyle>
    <p:bodyStyle>
      <a:lvl1pPr marL="435161" indent="-435161" algn="l" defTabSz="1740640" rtl="0" eaLnBrk="1" latinLnBrk="0" hangingPunct="1">
        <a:lnSpc>
          <a:spcPct val="90000"/>
        </a:lnSpc>
        <a:spcBef>
          <a:spcPts val="1903"/>
        </a:spcBef>
        <a:buFont typeface="Arial" panose="020B0604020202020204" pitchFamily="34" charset="0"/>
        <a:buChar char="•"/>
        <a:defRPr sz="5332" kern="1200">
          <a:solidFill>
            <a:schemeClr val="tx1">
              <a:lumMod val="10000"/>
            </a:schemeClr>
          </a:solidFill>
          <a:latin typeface="+mn-lt"/>
          <a:ea typeface="+mn-ea"/>
          <a:cs typeface="+mn-cs"/>
        </a:defRPr>
      </a:lvl1pPr>
      <a:lvl2pPr marL="1305482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4568" kern="1200">
          <a:solidFill>
            <a:schemeClr val="tx1">
              <a:lumMod val="10000"/>
            </a:schemeClr>
          </a:solidFill>
          <a:latin typeface="+mn-lt"/>
          <a:ea typeface="+mn-ea"/>
          <a:cs typeface="+mn-cs"/>
        </a:defRPr>
      </a:lvl2pPr>
      <a:lvl3pPr marL="2175800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3809" kern="1200">
          <a:solidFill>
            <a:schemeClr val="tx1">
              <a:lumMod val="10000"/>
            </a:schemeClr>
          </a:solidFill>
          <a:latin typeface="+mn-lt"/>
          <a:ea typeface="+mn-ea"/>
          <a:cs typeface="+mn-cs"/>
        </a:defRPr>
      </a:lvl3pPr>
      <a:lvl4pPr marL="3046121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3426" kern="1200">
          <a:solidFill>
            <a:schemeClr val="tx1">
              <a:lumMod val="10000"/>
            </a:schemeClr>
          </a:solidFill>
          <a:latin typeface="+mn-lt"/>
          <a:ea typeface="+mn-ea"/>
          <a:cs typeface="+mn-cs"/>
        </a:defRPr>
      </a:lvl4pPr>
      <a:lvl5pPr marL="3916442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3426" kern="1200">
          <a:solidFill>
            <a:schemeClr val="tx1">
              <a:lumMod val="10000"/>
            </a:schemeClr>
          </a:solidFill>
          <a:latin typeface="+mn-lt"/>
          <a:ea typeface="+mn-ea"/>
          <a:cs typeface="+mn-cs"/>
        </a:defRPr>
      </a:lvl5pPr>
      <a:lvl6pPr marL="4786763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3426" kern="1200">
          <a:solidFill>
            <a:schemeClr val="tx1"/>
          </a:solidFill>
          <a:latin typeface="+mn-lt"/>
          <a:ea typeface="+mn-ea"/>
          <a:cs typeface="+mn-cs"/>
        </a:defRPr>
      </a:lvl6pPr>
      <a:lvl7pPr marL="5657082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3426" kern="1200">
          <a:solidFill>
            <a:schemeClr val="tx1"/>
          </a:solidFill>
          <a:latin typeface="+mn-lt"/>
          <a:ea typeface="+mn-ea"/>
          <a:cs typeface="+mn-cs"/>
        </a:defRPr>
      </a:lvl7pPr>
      <a:lvl8pPr marL="6527403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3426" kern="1200">
          <a:solidFill>
            <a:schemeClr val="tx1"/>
          </a:solidFill>
          <a:latin typeface="+mn-lt"/>
          <a:ea typeface="+mn-ea"/>
          <a:cs typeface="+mn-cs"/>
        </a:defRPr>
      </a:lvl8pPr>
      <a:lvl9pPr marL="7397724" indent="-435161" algn="l" defTabSz="1740640" rtl="0" eaLnBrk="1" latinLnBrk="0" hangingPunct="1">
        <a:lnSpc>
          <a:spcPct val="90000"/>
        </a:lnSpc>
        <a:spcBef>
          <a:spcPts val="951"/>
        </a:spcBef>
        <a:buFont typeface="Arial" panose="020B0604020202020204" pitchFamily="34" charset="0"/>
        <a:buChar char="•"/>
        <a:defRPr sz="34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1pPr>
      <a:lvl2pPr marL="870318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2pPr>
      <a:lvl3pPr marL="1740640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3pPr>
      <a:lvl4pPr marL="2610961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4pPr>
      <a:lvl5pPr marL="3481282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5pPr>
      <a:lvl6pPr marL="4351603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6pPr>
      <a:lvl7pPr marL="5221921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7pPr>
      <a:lvl8pPr marL="6092245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8pPr>
      <a:lvl9pPr marL="6962563" algn="l" defTabSz="1740640" rtl="0" eaLnBrk="1" latinLnBrk="0" hangingPunct="1">
        <a:defRPr sz="34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Rectangle 92">
            <a:extLst>
              <a:ext uri="{FF2B5EF4-FFF2-40B4-BE49-F238E27FC236}">
                <a16:creationId xmlns:a16="http://schemas.microsoft.com/office/drawing/2014/main" id="{F28A8D2A-65DB-50E7-0523-71954671BB53}"/>
              </a:ext>
            </a:extLst>
          </p:cNvPr>
          <p:cNvSpPr/>
          <p:nvPr/>
        </p:nvSpPr>
        <p:spPr>
          <a:xfrm>
            <a:off x="33527999" y="6629400"/>
            <a:ext cx="8961120" cy="6675120"/>
          </a:xfrm>
          <a:prstGeom prst="rect">
            <a:avLst/>
          </a:prstGeom>
          <a:ln>
            <a:solidFill>
              <a:srgbClr val="FF9E6D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4337" dirty="0">
              <a:solidFill>
                <a:schemeClr val="tx1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E1C69082-3743-8B44-C5A0-E24970630979}"/>
              </a:ext>
            </a:extLst>
          </p:cNvPr>
          <p:cNvSpPr/>
          <p:nvPr/>
        </p:nvSpPr>
        <p:spPr>
          <a:xfrm>
            <a:off x="14630399" y="6629400"/>
            <a:ext cx="8961120" cy="6675120"/>
          </a:xfrm>
          <a:prstGeom prst="rect">
            <a:avLst/>
          </a:prstGeom>
          <a:ln>
            <a:solidFill>
              <a:srgbClr val="FF9E6D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4337" dirty="0">
              <a:solidFill>
                <a:schemeClr val="tx1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D6176B6-A86B-2DFD-67E2-19FA7D05355B}"/>
              </a:ext>
            </a:extLst>
          </p:cNvPr>
          <p:cNvSpPr>
            <a:spLocks noGrp="1" noRot="1" noMove="1" noResize="1" noEditPoints="1" noAdjustHandles="1" noChangeArrowheads="1" noChangeShapeType="1"/>
          </p:cNvSpPr>
          <p:nvPr/>
        </p:nvSpPr>
        <p:spPr>
          <a:xfrm>
            <a:off x="1" y="0"/>
            <a:ext cx="14199238" cy="21031200"/>
          </a:xfrm>
          <a:prstGeom prst="rect">
            <a:avLst/>
          </a:prstGeom>
          <a:solidFill>
            <a:srgbClr val="FF681D"/>
          </a:solidFill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endParaRPr lang="en-US" sz="52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ight Arrow 8">
            <a:extLst>
              <a:ext uri="{FF2B5EF4-FFF2-40B4-BE49-F238E27FC236}">
                <a16:creationId xmlns:a16="http://schemas.microsoft.com/office/drawing/2014/main" id="{434A908E-38F0-AE63-B60F-B7B7447A01BA}"/>
              </a:ext>
            </a:extLst>
          </p:cNvPr>
          <p:cNvSpPr/>
          <p:nvPr/>
        </p:nvSpPr>
        <p:spPr>
          <a:xfrm>
            <a:off x="2295069" y="17297400"/>
            <a:ext cx="1196601" cy="655282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3687"/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922BC05-F88B-0973-D491-DEFBC7E75B01}"/>
              </a:ext>
            </a:extLst>
          </p:cNvPr>
          <p:cNvCxnSpPr>
            <a:cxnSpLocks/>
          </p:cNvCxnSpPr>
          <p:nvPr/>
        </p:nvCxnSpPr>
        <p:spPr>
          <a:xfrm>
            <a:off x="14630400" y="350520"/>
            <a:ext cx="8686800" cy="0"/>
          </a:xfrm>
          <a:prstGeom prst="line">
            <a:avLst/>
          </a:prstGeom>
          <a:ln w="7620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744CC482-C729-5CA5-49C8-DBC4DF440846}"/>
              </a:ext>
            </a:extLst>
          </p:cNvPr>
          <p:cNvSpPr txBox="1"/>
          <p:nvPr/>
        </p:nvSpPr>
        <p:spPr>
          <a:xfrm>
            <a:off x="14630400" y="1171870"/>
            <a:ext cx="8686800" cy="4154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oxysmal nocturnal hemoglobinuria (PNH) is a rare, acquired, life-threatening disease characterized by chronic complement-mediated hemolysis and thrombosis</a:t>
            </a:r>
            <a:r>
              <a:rPr lang="en-US" sz="24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,2</a:t>
            </a:r>
          </a:p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with PNH experience anemia, fatigue, and dyspnea, and may require blood transfusions that can negatively impact quality of life</a:t>
            </a:r>
            <a:r>
              <a:rPr lang="en-US" sz="24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gcetacoplan </a:t>
            </a: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EG) provides comprehensive hemolysis control and 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 the first approved C3 inhibitor for US adults with PNH</a:t>
            </a:r>
            <a:r>
              <a:rPr lang="en-US" sz="24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EU adults with PNH who remain anemic despite stable C5 inhibitor treatment (</a:t>
            </a:r>
            <a:r>
              <a:rPr lang="en-US" sz="24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e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eculizumab [ECU] or ravulizumab) for ≥3 months</a:t>
            </a:r>
            <a:r>
              <a:rPr lang="en-US" sz="24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06F12504-A313-F79A-32AB-D769CBE244F8}"/>
              </a:ext>
            </a:extLst>
          </p:cNvPr>
          <p:cNvCxnSpPr>
            <a:cxnSpLocks/>
          </p:cNvCxnSpPr>
          <p:nvPr/>
        </p:nvCxnSpPr>
        <p:spPr>
          <a:xfrm>
            <a:off x="24502207" y="350520"/>
            <a:ext cx="17996597" cy="0"/>
          </a:xfrm>
          <a:prstGeom prst="line">
            <a:avLst/>
          </a:prstGeom>
          <a:ln w="7620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136AF04-1652-7D50-38DE-7B5CAA837CD9}"/>
              </a:ext>
            </a:extLst>
          </p:cNvPr>
          <p:cNvCxnSpPr>
            <a:cxnSpLocks/>
          </p:cNvCxnSpPr>
          <p:nvPr/>
        </p:nvCxnSpPr>
        <p:spPr>
          <a:xfrm>
            <a:off x="14630400" y="5867400"/>
            <a:ext cx="27889200" cy="50075"/>
          </a:xfrm>
          <a:prstGeom prst="line">
            <a:avLst/>
          </a:prstGeom>
          <a:ln w="7620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7EB8417-EB40-D85A-AC54-3F1860400994}"/>
              </a:ext>
            </a:extLst>
          </p:cNvPr>
          <p:cNvSpPr txBox="1"/>
          <p:nvPr/>
        </p:nvSpPr>
        <p:spPr>
          <a:xfrm>
            <a:off x="14630398" y="5867400"/>
            <a:ext cx="39712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600" b="1" dirty="0">
                <a:solidFill>
                  <a:srgbClr val="FF681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FF4F185-CB5C-CCB5-8751-81FEA2FEF54F}"/>
              </a:ext>
            </a:extLst>
          </p:cNvPr>
          <p:cNvSpPr/>
          <p:nvPr/>
        </p:nvSpPr>
        <p:spPr>
          <a:xfrm>
            <a:off x="24094440" y="13639800"/>
            <a:ext cx="8961120" cy="6675120"/>
          </a:xfrm>
          <a:prstGeom prst="rect">
            <a:avLst/>
          </a:prstGeom>
          <a:ln>
            <a:solidFill>
              <a:srgbClr val="FF9E6D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4337" dirty="0">
              <a:solidFill>
                <a:schemeClr val="tx1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EBB6037-DD76-AB99-F53A-54EA523B1821}"/>
              </a:ext>
            </a:extLst>
          </p:cNvPr>
          <p:cNvSpPr txBox="1"/>
          <p:nvPr/>
        </p:nvSpPr>
        <p:spPr>
          <a:xfrm>
            <a:off x="24502207" y="388203"/>
            <a:ext cx="46061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600" b="1" dirty="0">
                <a:solidFill>
                  <a:srgbClr val="FF681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3B983EC-8CFA-6B63-87D4-1A0DF0BC2348}"/>
              </a:ext>
            </a:extLst>
          </p:cNvPr>
          <p:cNvSpPr txBox="1"/>
          <p:nvPr/>
        </p:nvSpPr>
        <p:spPr>
          <a:xfrm>
            <a:off x="14630400" y="388203"/>
            <a:ext cx="49268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600" b="1" dirty="0">
                <a:solidFill>
                  <a:srgbClr val="FF681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EXT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0C6A1E1-7DD8-8E70-6D02-522938ED88A6}"/>
              </a:ext>
            </a:extLst>
          </p:cNvPr>
          <p:cNvSpPr/>
          <p:nvPr/>
        </p:nvSpPr>
        <p:spPr>
          <a:xfrm>
            <a:off x="317821" y="7656585"/>
            <a:ext cx="13563599" cy="27066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JECTIVE</a:t>
            </a:r>
          </a:p>
          <a:p>
            <a:pPr marL="205109" algn="ctr">
              <a:spcAft>
                <a:spcPts val="600"/>
              </a:spcAft>
            </a:pP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aim of this post hoc analysis was to determine normalization rates for hemoglobin (Hb), lactate dehydrogenase (LDH), absolute reticulocyte count (ARC), and Functional Assessment of Chronic Illness Therapy (FACIT)-Fatigue and safety in a subgroup of patients with PNH and baseline Hb levels ≥10.0 g/dL treated with pegcetacoplan from the PEGASUS (NCT03500549), PADDOCK (NCT02588833), and PRINCE (NCT04085601) studies.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C97E5755-EDE1-B26D-94E3-31F009C292B3}"/>
              </a:ext>
            </a:extLst>
          </p:cNvPr>
          <p:cNvCxnSpPr>
            <a:cxnSpLocks/>
          </p:cNvCxnSpPr>
          <p:nvPr/>
        </p:nvCxnSpPr>
        <p:spPr>
          <a:xfrm>
            <a:off x="609600" y="15392400"/>
            <a:ext cx="12954000" cy="0"/>
          </a:xfrm>
          <a:prstGeom prst="line">
            <a:avLst/>
          </a:prstGeom>
          <a:ln w="635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A8D29A60-D30D-6046-8801-73711176C16A}"/>
              </a:ext>
            </a:extLst>
          </p:cNvPr>
          <p:cNvSpPr/>
          <p:nvPr/>
        </p:nvSpPr>
        <p:spPr>
          <a:xfrm>
            <a:off x="278786" y="0"/>
            <a:ext cx="13641669" cy="438912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Bef>
                <a:spcPts val="300"/>
              </a:spcBef>
              <a:spcAft>
                <a:spcPts val="300"/>
              </a:spcAft>
            </a:pPr>
            <a:r>
              <a:rPr lang="en-US" sz="4800" b="1" dirty="0">
                <a:latin typeface="Arial" panose="020B0604020202020204" pitchFamily="34" charset="0"/>
                <a:cs typeface="Arial" panose="020B0604020202020204" pitchFamily="34" charset="0"/>
              </a:rPr>
              <a:t>Normalization of Hematologic Markers and Fatigue in Patients with Paroxysmal Nocturnal Hemoglobinuria Treated with Pegcetacoplan and Baseline Hemoglobin at or Above 10 g/dL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D60C681-D888-7608-5E0B-5C80EF47E426}"/>
              </a:ext>
            </a:extLst>
          </p:cNvPr>
          <p:cNvSpPr txBox="1"/>
          <p:nvPr/>
        </p:nvSpPr>
        <p:spPr>
          <a:xfrm>
            <a:off x="7049674" y="15563195"/>
            <a:ext cx="6584966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cknowledgment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This study was funded by Apellis Pharmaceuticals, Inc. Writing and editorial support was provided by Boston Strategic Partners Inc. (funded by Apellis Pharmaceuticals, Inc.). Apellis Pharmaceuticals and Swedish Orphan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Biovitru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B reviewed the poster. 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sclosure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Desai, D: Reports current employment with Apellis Pharmaceuticals, Inc.;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ulheri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B. “nothing to declare”. Yeh, M. reports current employment and current equity holder in publicly-traded company for Apellis Pharmaceuticals. Al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dham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M. and Savage, J. report current employment with Apellis Pharmaceuticals.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ingl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D. reports consultancy and advisory board with Alexion, Apellis, Janssen,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illeneu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/Takeda, Novartis, R-Pharm, and Rigel and Sanofi; and research grant with Juno and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aryophar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ference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1. Parker C, et al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2005;106(12):3699–709. 2.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Risitan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, et al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iologics: Targets &amp; Therapy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2008;2(2):205-255. 3. Castro C,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Gross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F, Weitz IC, et al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Am J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Hemato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2020;95(11):1334–1343. 4. Apellis Pharmaceuticals. EMPAVELI (pegcetacoplan) [Package Insert]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US Food and Drug Administratio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2021. 5. Apellis Pharmaceuticals. ASPAVELI (pegcetacoplan) [Summary of Product Characteristics]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European Medicines Agency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2021. 6.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effaul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e Latour R, et al. EHA Library. 2021; 324582; S174. 7. Wong RS, et al., Blood. 2020; 136 (Supplement 1):3-4. 8. Wong RS, et al. Blood. 2021; 138 (Supplement 1):606-608. 9. Cella D, et al., Cancer. 2002;94(2):528-538.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A23DF1D-0FDC-0AE0-AC00-31F88C73F7F9}"/>
              </a:ext>
            </a:extLst>
          </p:cNvPr>
          <p:cNvSpPr txBox="1"/>
          <p:nvPr/>
        </p:nvSpPr>
        <p:spPr>
          <a:xfrm>
            <a:off x="609600" y="15697200"/>
            <a:ext cx="600891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For additional information </a:t>
            </a:r>
          </a:p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or to receive a PDF of this poster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4349991-F38C-C561-5BB8-E3038CA8860B}"/>
              </a:ext>
            </a:extLst>
          </p:cNvPr>
          <p:cNvSpPr txBox="1">
            <a:spLocks noChangeAspect="1"/>
          </p:cNvSpPr>
          <p:nvPr/>
        </p:nvSpPr>
        <p:spPr>
          <a:xfrm>
            <a:off x="622620" y="3657600"/>
            <a:ext cx="12954001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200"/>
              </a:spcAft>
            </a:pPr>
            <a:r>
              <a:rPr lang="en-US" sz="2800" b="1" i="1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harmik</a:t>
            </a:r>
            <a:r>
              <a:rPr lang="en-US" sz="2800" b="1" i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sai, PharmD</a:t>
            </a:r>
            <a:r>
              <a:rPr lang="en-US" sz="2800" b="1" i="1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2800" i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resenting on behalf of study investigators: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Jens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se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icolas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guindau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onia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kuyama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égis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ffault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 Latour, MD, Ph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hilippe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hafhausen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icole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etmans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D, Ph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ohammed Al-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hami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h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mitayo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jayi, M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28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melie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ersson, Ph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8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ichael Yeh, MD, MBA, MPH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aymond Siu Ming Wong, MBChB, MD</a:t>
            </a:r>
            <a:r>
              <a:rPr lang="en-US" sz="28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2DF6544-B57C-87B3-AAD1-961AA3749270}"/>
              </a:ext>
            </a:extLst>
          </p:cNvPr>
          <p:cNvSpPr txBox="1"/>
          <p:nvPr/>
        </p:nvSpPr>
        <p:spPr>
          <a:xfrm>
            <a:off x="337688" y="5943600"/>
            <a:ext cx="135238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ellis Pharmaceuticals, Waltham, MA, USA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partment of Hematology, Oncology,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mostaseology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Stem Cell Transplantation, University Hospital RWTH Aachen, Aachen, Germany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ntre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ospitalier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necy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vois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Épagny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Metz-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ssy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France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matology/Oncology Division, Denver Health and Hospital Authority, Denver, CO, USA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ench Reference Center for Aplastic Anemia and Paroxysmal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ctural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emoglobinuria, Assistance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ublique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-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ôpitaux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 Paris; Université de Paris, Paris, France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cal Clinic and Polyclinic II - Hematology, Oncology, University Medical Center Hamburg-Eppendorf, Hamburg, Germany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partment of Hematology,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ques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iversitaires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aint-Luc,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oluwe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Saint-Lambert, Belgium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8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wedish Orphan </a:t>
            </a:r>
            <a:r>
              <a:rPr lang="en-US" sz="1400" dirty="0" err="1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iovitrum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B, Stockholm, Sweden; </a:t>
            </a:r>
            <a:r>
              <a:rPr lang="en-US" sz="1400" baseline="300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</a:t>
            </a:r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r Y.K. Pao Centre for Cancer &amp; Department of Medicine and Therapeutics, Prince of Wales Hospital, The Chinese University of Hong Kong, Hong Kong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4530778-3DAE-4F3C-730E-0B96DB22E0A1}"/>
              </a:ext>
            </a:extLst>
          </p:cNvPr>
          <p:cNvSpPr txBox="1"/>
          <p:nvPr/>
        </p:nvSpPr>
        <p:spPr>
          <a:xfrm>
            <a:off x="5824604" y="19964400"/>
            <a:ext cx="796759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ciety of Hematologic Oncology (SOHO)| </a:t>
            </a:r>
          </a:p>
          <a:p>
            <a:pPr algn="r"/>
            <a:r>
              <a:rPr lang="en-US" sz="2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pt 28–Oct 1, 2022 | Houston, TX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5CD08B1-4A69-53B2-812A-C6FBA9E9D2C2}"/>
              </a:ext>
            </a:extLst>
          </p:cNvPr>
          <p:cNvSpPr txBox="1"/>
          <p:nvPr/>
        </p:nvSpPr>
        <p:spPr>
          <a:xfrm>
            <a:off x="24502207" y="1171870"/>
            <a:ext cx="17687797" cy="4154984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rolled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s had PNH and anemia (hemoglobin [Hb] &lt;10.5 g/dL) despite ≥3 months ECU treatment (PEGASUS)</a:t>
            </a:r>
            <a:r>
              <a:rPr lang="en-US" sz="24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were naïve to complement inhibitor therapy and received supportive care only (blood transfusions, corticosteroids, anticoagulants, and supplements [iron, folate, B12] in countries where complement inhibitors were not approved or widely available; PADDOCK</a:t>
            </a:r>
            <a:r>
              <a:rPr lang="en-US" sz="24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PRINCE</a:t>
            </a:r>
            <a:r>
              <a:rPr lang="en-US" sz="24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 post hoc analysis included adults with PNH, baseline Hb levels ≥10.0 g/dL, and no transfusions within 14 days of baselin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ation of hematologic and fatigue endpoints were evaluated after 16 weeks of PEG monotherap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ation was defined as follows: Hb ≥ the lower limit of normal range (female: 12.0 g/dL, male 13.6 g/dL), lactate dehydrogenase (LDH) ≤ the upper limit of normal (226.0 U/L), absolute reticulocyte count (ARC) ≤ the upper limit of normal (120.0x10</a:t>
            </a:r>
            <a:r>
              <a:rPr lang="en-US" sz="2400" baseline="300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/L), Functional Assessment of Chronic Illness Therapy (FACIT)-Fatigue ≥ the general population norm (43.6)</a:t>
            </a:r>
            <a:r>
              <a:rPr lang="en-US" sz="2400" baseline="300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2400" dirty="0">
              <a:solidFill>
                <a:schemeClr val="tx1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who received transfusions (PRINCE only), withdrew from the study, escaped from control (supportive care only) to</a:t>
            </a:r>
            <a:r>
              <a:rPr lang="en-US" sz="2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G, or were missing data at the specified time point were considered not normalized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240442E-985B-3A94-1D44-98F321B8D5EF}"/>
              </a:ext>
            </a:extLst>
          </p:cNvPr>
          <p:cNvSpPr txBox="1"/>
          <p:nvPr/>
        </p:nvSpPr>
        <p:spPr>
          <a:xfrm>
            <a:off x="14740979" y="7538621"/>
            <a:ext cx="8686800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all, 23 patients had Hb levels ≥10.0 g/dL at baseline:</a:t>
            </a:r>
          </a:p>
          <a:p>
            <a:pPr marL="914400" indent="-342900">
              <a:buFont typeface="Courier New" panose="02070309020205020404" pitchFamily="49" charset="0"/>
              <a:buChar char="o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GASUS: n=9 (PEG-to-PEG n=6, ECU-to-PEG n=3)</a:t>
            </a:r>
          </a:p>
          <a:p>
            <a:pPr marL="914400" indent="-342900">
              <a:buFont typeface="Courier New" panose="02070309020205020404" pitchFamily="49" charset="0"/>
              <a:buChar char="o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DOCK: n=6 (1 patient in PADDOCK that stopped dosing at Day 29 and left the study due to physician decision is not included in the normalization analysis) </a:t>
            </a:r>
          </a:p>
          <a:p>
            <a:pPr marL="914400" indent="-342900">
              <a:buFont typeface="Courier New" panose="02070309020205020404" pitchFamily="49" charset="0"/>
              <a:buChar char="o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NCE: n=8</a:t>
            </a:r>
          </a:p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 age (range) in years was similar across studies: PEGASUS, 49.0 (34.0–72.0); PADDOCK, 41.3 (22.0–67.0); PRINCE, 44.0 (30.0–63.0)</a:t>
            </a:r>
          </a:p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ortion of female patients, n (%): PEGASUS, 5 (55.6); PADDOCK, 3 (50.0); PRINCE, 2 (25.0)</a:t>
            </a:r>
          </a:p>
          <a:p>
            <a:pPr marL="300426" indent="-300426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an years (range) since PNH diagnosis: PEGASUS, 6.0 (3.4–24.1); PADDOCK, 6.4 (1.8–16.4); PRINCE, 1.5 (0.4–14.0)</a:t>
            </a:r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A9D37E92-47FD-482C-F549-E63C8B7D556A}"/>
              </a:ext>
            </a:extLst>
          </p:cNvPr>
          <p:cNvSpPr/>
          <p:nvPr/>
        </p:nvSpPr>
        <p:spPr>
          <a:xfrm>
            <a:off x="457200" y="19553243"/>
            <a:ext cx="2328583" cy="1235979"/>
          </a:xfrm>
          <a:prstGeom prst="ellipse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DS-11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459B66F-6572-0092-90DC-110AD8ABEE45}"/>
              </a:ext>
            </a:extLst>
          </p:cNvPr>
          <p:cNvSpPr txBox="1"/>
          <p:nvPr/>
        </p:nvSpPr>
        <p:spPr>
          <a:xfrm>
            <a:off x="14635790" y="20497800"/>
            <a:ext cx="27889200" cy="451406"/>
          </a:xfrm>
          <a:prstGeom prst="rect">
            <a:avLst/>
          </a:prstGeom>
          <a:noFill/>
          <a:ln>
            <a:solidFill>
              <a:schemeClr val="tx1">
                <a:lumMod val="10000"/>
              </a:schemeClr>
            </a:solidFill>
          </a:ln>
        </p:spPr>
        <p:txBody>
          <a:bodyPr wrap="square" rtlCol="0">
            <a:spAutoFit/>
          </a:bodyPr>
          <a:lstStyle/>
          <a:p>
            <a:pPr marL="70734" defTabSz="2695603">
              <a:lnSpc>
                <a:spcPts val="1406"/>
              </a:lnSpc>
              <a:spcBef>
                <a:spcPts val="281"/>
              </a:spcBef>
              <a:defRPr/>
            </a:pPr>
            <a:r>
              <a:rPr lang="en-US" sz="14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breviations: AE(s), adverse event(s); ARC, absolute reticulocyte count; ECU, eculizumab; ECU-to-PEG, eculizumab treatment for 16 weeks then switched to pegcetacoplan through Week 48; FACIT, Functional Assessment of Chronic Illness Therapy; Hb, hemoglobin; LDH, Lactate dehydrogenase; PEG, pegcetacoplan; PEG-to-PEG: pegcetacoplan treatment for 16 weeks, then continued through Week 48; PNH, paroxysmal nocturnal hemoglobinuria. Control treatment was supportive care only (eg, transfusions, corticosteroids, anticoagulants, supplements [iron, folate, B12] in countries where complement inhibitors were not approved or widely available 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FB46AE3-C827-B965-1FB8-12674B47D331}"/>
              </a:ext>
            </a:extLst>
          </p:cNvPr>
          <p:cNvSpPr/>
          <p:nvPr/>
        </p:nvSpPr>
        <p:spPr>
          <a:xfrm>
            <a:off x="494479" y="10699552"/>
            <a:ext cx="13210283" cy="46166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US" sz="4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LUSIONS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85271AC9-1342-7DF2-D5AB-EA4201FC43EC}"/>
              </a:ext>
            </a:extLst>
          </p:cNvPr>
          <p:cNvSpPr/>
          <p:nvPr/>
        </p:nvSpPr>
        <p:spPr>
          <a:xfrm>
            <a:off x="24094440" y="13639799"/>
            <a:ext cx="8961120" cy="640080"/>
          </a:xfrm>
          <a:prstGeom prst="rect">
            <a:avLst/>
          </a:prstGeom>
          <a:solidFill>
            <a:srgbClr val="6099B0"/>
          </a:solidFill>
          <a:ln>
            <a:solidFill>
              <a:srgbClr val="005D8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RC Normalization </a:t>
            </a:r>
          </a:p>
        </p:txBody>
      </p:sp>
      <p:graphicFrame>
        <p:nvGraphicFramePr>
          <p:cNvPr id="59" name="Chart 58">
            <a:extLst>
              <a:ext uri="{FF2B5EF4-FFF2-40B4-BE49-F238E27FC236}">
                <a16:creationId xmlns:a16="http://schemas.microsoft.com/office/drawing/2014/main" id="{A4BA7F41-3353-F717-055B-2840FAC020E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76510893"/>
              </p:ext>
            </p:extLst>
          </p:nvPr>
        </p:nvGraphicFramePr>
        <p:xfrm>
          <a:off x="25115520" y="7258190"/>
          <a:ext cx="7863840" cy="6126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4" name="Group 93">
            <a:extLst>
              <a:ext uri="{FF2B5EF4-FFF2-40B4-BE49-F238E27FC236}">
                <a16:creationId xmlns:a16="http://schemas.microsoft.com/office/drawing/2014/main" id="{D32353A2-421E-290F-2093-E8A69E4F2955}"/>
              </a:ext>
            </a:extLst>
          </p:cNvPr>
          <p:cNvGrpSpPr/>
          <p:nvPr/>
        </p:nvGrpSpPr>
        <p:grpSpPr>
          <a:xfrm rot="16200000">
            <a:off x="23547608" y="11219773"/>
            <a:ext cx="2286001" cy="916032"/>
            <a:chOff x="14274500" y="14554105"/>
            <a:chExt cx="2286001" cy="916032"/>
          </a:xfrm>
        </p:grpSpPr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B84BF950-B908-DD7C-DA07-750F976A453D}"/>
                </a:ext>
              </a:extLst>
            </p:cNvPr>
            <p:cNvSpPr txBox="1"/>
            <p:nvPr/>
          </p:nvSpPr>
          <p:spPr>
            <a:xfrm>
              <a:off x="14274500" y="15070027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8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B59401CD-A415-2165-55C5-450DF3BFCA70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INCE</a:t>
              </a: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A4BF8B4A-526F-CC5E-4C7E-14371BB42B42}"/>
              </a:ext>
            </a:extLst>
          </p:cNvPr>
          <p:cNvGrpSpPr/>
          <p:nvPr/>
        </p:nvGrpSpPr>
        <p:grpSpPr>
          <a:xfrm rot="16200000">
            <a:off x="23524402" y="9571878"/>
            <a:ext cx="2286001" cy="916033"/>
            <a:chOff x="14274500" y="14554105"/>
            <a:chExt cx="2286001" cy="916033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BBF73D72-A401-6D11-7A31-5B8886304816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AB6E46E3-FD56-DDBA-FF5F-64966DA51BDF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ADDOCK</a:t>
              </a:r>
            </a:p>
          </p:txBody>
        </p: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B5FF3A70-1325-A535-B6D0-B0B110CF4233}"/>
              </a:ext>
            </a:extLst>
          </p:cNvPr>
          <p:cNvGrpSpPr/>
          <p:nvPr/>
        </p:nvGrpSpPr>
        <p:grpSpPr>
          <a:xfrm rot="16200000">
            <a:off x="23501195" y="7923984"/>
            <a:ext cx="2286001" cy="916033"/>
            <a:chOff x="14274500" y="14554105"/>
            <a:chExt cx="2286001" cy="916033"/>
          </a:xfrm>
        </p:grpSpPr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8C41C69-7FDB-4079-F2C2-964AA09145DF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CA3996D3-714E-5A30-9457-EFF9DECA3704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GASUS</a:t>
              </a:r>
            </a:p>
          </p:txBody>
        </p:sp>
      </p:grpSp>
      <p:graphicFrame>
        <p:nvGraphicFramePr>
          <p:cNvPr id="66" name="Chart 65">
            <a:extLst>
              <a:ext uri="{FF2B5EF4-FFF2-40B4-BE49-F238E27FC236}">
                <a16:creationId xmlns:a16="http://schemas.microsoft.com/office/drawing/2014/main" id="{C6EF4624-CEFA-FE89-846B-9A48E046A95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49591098"/>
              </p:ext>
            </p:extLst>
          </p:nvPr>
        </p:nvGraphicFramePr>
        <p:xfrm>
          <a:off x="25085040" y="14325600"/>
          <a:ext cx="7863840" cy="6126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03" name="Group 102">
            <a:extLst>
              <a:ext uri="{FF2B5EF4-FFF2-40B4-BE49-F238E27FC236}">
                <a16:creationId xmlns:a16="http://schemas.microsoft.com/office/drawing/2014/main" id="{427E8C13-6DF7-E8E6-2034-95E2FD77391E}"/>
              </a:ext>
            </a:extLst>
          </p:cNvPr>
          <p:cNvGrpSpPr/>
          <p:nvPr/>
        </p:nvGrpSpPr>
        <p:grpSpPr>
          <a:xfrm rot="16200000">
            <a:off x="23488757" y="18230174"/>
            <a:ext cx="2286001" cy="916032"/>
            <a:chOff x="14274500" y="14554105"/>
            <a:chExt cx="2286001" cy="916032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5FC2DE57-DA26-4F8B-9C5D-1A26D2E06FA8}"/>
                </a:ext>
              </a:extLst>
            </p:cNvPr>
            <p:cNvSpPr txBox="1"/>
            <p:nvPr/>
          </p:nvSpPr>
          <p:spPr>
            <a:xfrm>
              <a:off x="14274500" y="15070027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8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66A52690-9344-FFBC-58D3-907E6ECB9F5C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INCE</a:t>
              </a:r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05203DBC-0F7E-FF4A-3584-264EE428D42A}"/>
              </a:ext>
            </a:extLst>
          </p:cNvPr>
          <p:cNvGrpSpPr/>
          <p:nvPr/>
        </p:nvGrpSpPr>
        <p:grpSpPr>
          <a:xfrm rot="16200000">
            <a:off x="23465551" y="16582279"/>
            <a:ext cx="2286001" cy="916033"/>
            <a:chOff x="14274500" y="14554105"/>
            <a:chExt cx="2286001" cy="916033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9F4344C8-66CA-6092-6C30-411B0267D664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E0998358-9D72-3324-890E-25E820363CE1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ADDOCK</a:t>
              </a:r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1E3DE718-22F2-7C82-1D92-27FCBFC0B7A4}"/>
              </a:ext>
            </a:extLst>
          </p:cNvPr>
          <p:cNvGrpSpPr/>
          <p:nvPr/>
        </p:nvGrpSpPr>
        <p:grpSpPr>
          <a:xfrm rot="16200000">
            <a:off x="23442344" y="14934385"/>
            <a:ext cx="2286001" cy="916033"/>
            <a:chOff x="14274500" y="14554105"/>
            <a:chExt cx="2286001" cy="916033"/>
          </a:xfrm>
        </p:grpSpPr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CC9C7FAF-196D-37A0-C369-8335943FB4B9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5181AA3F-2805-5028-C37C-9EFD11C0A880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GASUS</a:t>
              </a:r>
            </a:p>
          </p:txBody>
        </p:sp>
      </p:grpSp>
      <p:graphicFrame>
        <p:nvGraphicFramePr>
          <p:cNvPr id="117" name="Chart 116">
            <a:extLst>
              <a:ext uri="{FF2B5EF4-FFF2-40B4-BE49-F238E27FC236}">
                <a16:creationId xmlns:a16="http://schemas.microsoft.com/office/drawing/2014/main" id="{C72FB488-20A5-7298-A8BB-C102ADD0412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04378308"/>
              </p:ext>
            </p:extLst>
          </p:nvPr>
        </p:nvGraphicFramePr>
        <p:xfrm>
          <a:off x="34472880" y="7199205"/>
          <a:ext cx="7955280" cy="59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9" name="Table 118">
            <a:extLst>
              <a:ext uri="{FF2B5EF4-FFF2-40B4-BE49-F238E27FC236}">
                <a16:creationId xmlns:a16="http://schemas.microsoft.com/office/drawing/2014/main" id="{5D710DC0-6189-8E4C-468F-5FE4E4BFE1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8855314"/>
              </p:ext>
            </p:extLst>
          </p:nvPr>
        </p:nvGraphicFramePr>
        <p:xfrm>
          <a:off x="33540833" y="14263378"/>
          <a:ext cx="8961120" cy="4715890"/>
        </p:xfrm>
        <a:graphic>
          <a:graphicData uri="http://schemas.openxmlformats.org/drawingml/2006/table">
            <a:tbl>
              <a:tblPr firstRow="1" firstCol="1" bandRow="1"/>
              <a:tblGrid>
                <a:gridCol w="4050917">
                  <a:extLst>
                    <a:ext uri="{9D8B030D-6E8A-4147-A177-3AD203B41FA5}">
                      <a16:colId xmlns:a16="http://schemas.microsoft.com/office/drawing/2014/main" val="3331696190"/>
                    </a:ext>
                  </a:extLst>
                </a:gridCol>
                <a:gridCol w="1657193">
                  <a:extLst>
                    <a:ext uri="{9D8B030D-6E8A-4147-A177-3AD203B41FA5}">
                      <a16:colId xmlns:a16="http://schemas.microsoft.com/office/drawing/2014/main" val="3310990087"/>
                    </a:ext>
                  </a:extLst>
                </a:gridCol>
                <a:gridCol w="1749260">
                  <a:extLst>
                    <a:ext uri="{9D8B030D-6E8A-4147-A177-3AD203B41FA5}">
                      <a16:colId xmlns:a16="http://schemas.microsoft.com/office/drawing/2014/main" val="2534001082"/>
                    </a:ext>
                  </a:extLst>
                </a:gridCol>
                <a:gridCol w="1503750">
                  <a:extLst>
                    <a:ext uri="{9D8B030D-6E8A-4147-A177-3AD203B41FA5}">
                      <a16:colId xmlns:a16="http://schemas.microsoft.com/office/drawing/2014/main" val="3234896911"/>
                    </a:ext>
                  </a:extLst>
                </a:gridCol>
              </a:tblGrid>
              <a:tr h="958195"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2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ASUS</a:t>
                      </a:r>
                    </a:p>
                    <a:p>
                      <a:pPr algn="ctr"/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9</a:t>
                      </a:r>
                      <a:endParaRPr lang="en-US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2B5D76"/>
                    </a:solidFill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DDOCK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=6</a:t>
                      </a:r>
                      <a:r>
                        <a:rPr lang="en-US" sz="240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2B5D76"/>
                    </a:solidFill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NCE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=8</a:t>
                      </a: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2B5D7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0202323"/>
                  </a:ext>
                </a:extLst>
              </a:tr>
              <a:tr h="640080"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y AEs</a:t>
                      </a:r>
                      <a:r>
                        <a:rPr lang="en-US" sz="2400" b="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 (%)</a:t>
                      </a:r>
                      <a:endParaRPr lang="en-US" sz="2400" b="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77.8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66.7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87.5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9511575"/>
                  </a:ext>
                </a:extLst>
              </a:tr>
              <a:tr h="640080"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ous AEs</a:t>
                      </a:r>
                      <a:r>
                        <a:rPr lang="en-US" sz="2400" b="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 (%)</a:t>
                      </a:r>
                      <a:endParaRPr lang="en-US" sz="2400" b="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.1)</a:t>
                      </a:r>
                      <a:r>
                        <a:rPr lang="en-US" sz="2400" baseline="300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8287549"/>
                  </a:ext>
                </a:extLst>
              </a:tr>
              <a:tr h="958195"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jection Site Reactions</a:t>
                      </a:r>
                      <a:r>
                        <a:rPr lang="en-US" sz="2400" b="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</a:p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%)</a:t>
                      </a:r>
                      <a:endParaRPr lang="en-US" sz="2400" b="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.3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2.5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388049"/>
                  </a:ext>
                </a:extLst>
              </a:tr>
              <a:tr h="958195"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ections and </a:t>
                      </a:r>
                      <a:r>
                        <a:rPr lang="en-US" sz="2400" dirty="0" err="1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estations</a:t>
                      </a:r>
                      <a:r>
                        <a:rPr lang="en-US" sz="2400" baseline="30000" dirty="0" err="1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2400" b="0" baseline="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 (%)</a:t>
                      </a:r>
                      <a:endParaRPr lang="en-US" sz="2400" b="0" baseline="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.3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2.5)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6260537"/>
                  </a:ext>
                </a:extLst>
              </a:tr>
              <a:tr h="561145"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rombotic Events</a:t>
                      </a:r>
                      <a:r>
                        <a:rPr lang="en-US" sz="2400" b="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 (%)</a:t>
                      </a:r>
                      <a:endParaRPr lang="en-US" sz="2400" b="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870318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740640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61096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3481282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435160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5221921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6092245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6962563" algn="l" defTabSz="1740640" rtl="0" eaLnBrk="1" latinLnBrk="0" hangingPunct="1">
                        <a:defRPr sz="3426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chemeClr val="tx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2400" dirty="0">
                        <a:solidFill>
                          <a:schemeClr val="tx2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83" marR="66583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05325"/>
                  </a:ext>
                </a:extLst>
              </a:tr>
            </a:tbl>
          </a:graphicData>
        </a:graphic>
      </p:graphicFrame>
      <p:grpSp>
        <p:nvGrpSpPr>
          <p:cNvPr id="120" name="Group 119">
            <a:extLst>
              <a:ext uri="{FF2B5EF4-FFF2-40B4-BE49-F238E27FC236}">
                <a16:creationId xmlns:a16="http://schemas.microsoft.com/office/drawing/2014/main" id="{D691D566-A3D6-49A4-CB76-26990B0F50AB}"/>
              </a:ext>
            </a:extLst>
          </p:cNvPr>
          <p:cNvGrpSpPr/>
          <p:nvPr/>
        </p:nvGrpSpPr>
        <p:grpSpPr>
          <a:xfrm rot="16200000">
            <a:off x="32944140" y="10779788"/>
            <a:ext cx="2286001" cy="916032"/>
            <a:chOff x="14274500" y="14554105"/>
            <a:chExt cx="2286001" cy="916032"/>
          </a:xfrm>
        </p:grpSpPr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5BE80EE-A249-2760-E7AA-3DF1EFEFB463}"/>
                </a:ext>
              </a:extLst>
            </p:cNvPr>
            <p:cNvSpPr txBox="1"/>
            <p:nvPr/>
          </p:nvSpPr>
          <p:spPr>
            <a:xfrm>
              <a:off x="14274500" y="15070027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8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08F45F98-974F-151D-F7E8-EA40CB809893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INCE</a:t>
              </a:r>
            </a:p>
          </p:txBody>
        </p: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271BD220-1FBF-DABC-6373-28DE273553D4}"/>
              </a:ext>
            </a:extLst>
          </p:cNvPr>
          <p:cNvGrpSpPr/>
          <p:nvPr/>
        </p:nvGrpSpPr>
        <p:grpSpPr>
          <a:xfrm rot="16200000">
            <a:off x="32944140" y="9237585"/>
            <a:ext cx="2286001" cy="916033"/>
            <a:chOff x="14274500" y="14554105"/>
            <a:chExt cx="2286001" cy="916033"/>
          </a:xfrm>
        </p:grpSpPr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6E38E7C0-30D7-A9BD-822E-12793A339B99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B5F6BDA5-C18C-173A-D742-2374C6B544EC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ADDOCK</a:t>
              </a:r>
            </a:p>
          </p:txBody>
        </p:sp>
      </p:grp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F18D9A8A-B722-FEF6-B749-734A11B9F8ED}"/>
              </a:ext>
            </a:extLst>
          </p:cNvPr>
          <p:cNvGrpSpPr/>
          <p:nvPr/>
        </p:nvGrpSpPr>
        <p:grpSpPr>
          <a:xfrm rot="16200000">
            <a:off x="32944140" y="7695384"/>
            <a:ext cx="2286001" cy="916033"/>
            <a:chOff x="14274500" y="14554105"/>
            <a:chExt cx="2286001" cy="916033"/>
          </a:xfrm>
        </p:grpSpPr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5B386CC-B1AF-0D79-A1D4-B6210537895F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2F5AC745-D459-923A-50C3-15B709B8E845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GASUS</a:t>
              </a:r>
              <a:r>
                <a:rPr kumimoji="0" lang="en-US" sz="2000" b="1" i="0" u="sng" strike="noStrike" kern="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en-US" sz="2000" b="1" i="0" u="sng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9" name="TextBox 128">
            <a:extLst>
              <a:ext uri="{FF2B5EF4-FFF2-40B4-BE49-F238E27FC236}">
                <a16:creationId xmlns:a16="http://schemas.microsoft.com/office/drawing/2014/main" id="{A48E71B8-7725-3707-D546-7A51C0F390D2}"/>
              </a:ext>
            </a:extLst>
          </p:cNvPr>
          <p:cNvSpPr txBox="1"/>
          <p:nvPr/>
        </p:nvSpPr>
        <p:spPr>
          <a:xfrm>
            <a:off x="33573719" y="12801600"/>
            <a:ext cx="8869680" cy="5366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319636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30000" noProof="0" dirty="0" err="1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provements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FACIT-Fatigue normalization for the PEGASUS subgroup were observed only in the PEG-to-PEG arm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A36DAC1-D66A-7A35-017F-B6A9E26BCA92}"/>
              </a:ext>
            </a:extLst>
          </p:cNvPr>
          <p:cNvSpPr/>
          <p:nvPr/>
        </p:nvSpPr>
        <p:spPr>
          <a:xfrm>
            <a:off x="33527999" y="6629400"/>
            <a:ext cx="8961120" cy="640080"/>
          </a:xfrm>
          <a:prstGeom prst="rect">
            <a:avLst/>
          </a:prstGeom>
          <a:solidFill>
            <a:srgbClr val="6099B0"/>
          </a:solidFill>
          <a:ln>
            <a:solidFill>
              <a:srgbClr val="005D8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FACIT-Fatigue Normalization</a:t>
            </a:r>
            <a:endParaRPr lang="en-US" sz="36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6B750D9E-34FA-F166-4223-7CEDDCB5E8B7}"/>
              </a:ext>
            </a:extLst>
          </p:cNvPr>
          <p:cNvSpPr/>
          <p:nvPr/>
        </p:nvSpPr>
        <p:spPr>
          <a:xfrm>
            <a:off x="33540833" y="13639799"/>
            <a:ext cx="8961120" cy="6675120"/>
          </a:xfrm>
          <a:prstGeom prst="rect">
            <a:avLst/>
          </a:prstGeom>
          <a:noFill/>
          <a:ln>
            <a:solidFill>
              <a:srgbClr val="FF9E6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466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8FC15AAF-5361-4EFC-01EF-05C09664BA32}"/>
              </a:ext>
            </a:extLst>
          </p:cNvPr>
          <p:cNvSpPr/>
          <p:nvPr/>
        </p:nvSpPr>
        <p:spPr>
          <a:xfrm>
            <a:off x="33540833" y="13639799"/>
            <a:ext cx="8961120" cy="640080"/>
          </a:xfrm>
          <a:prstGeom prst="rect">
            <a:avLst/>
          </a:prstGeom>
          <a:solidFill>
            <a:srgbClr val="6099B0"/>
          </a:solidFill>
          <a:ln>
            <a:solidFill>
              <a:srgbClr val="005D8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fety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1180C13F-4195-840C-A99D-68CF08191660}"/>
              </a:ext>
            </a:extLst>
          </p:cNvPr>
          <p:cNvSpPr txBox="1"/>
          <p:nvPr/>
        </p:nvSpPr>
        <p:spPr>
          <a:xfrm>
            <a:off x="33588962" y="18973800"/>
            <a:ext cx="893063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31963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30000" noProof="0" dirty="0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One PADDOCK patient who discontinued the study at Day 29 (physician decision) was excluded from normalization analyses, but included in this safety analysis</a:t>
            </a:r>
          </a:p>
          <a:p>
            <a:pPr marL="0" marR="0" lvl="0" indent="0" defTabSz="431963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30000" noProof="0" dirty="0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The serious adverse event was documented as breakthrough hemolysis and considered unrelated to pegcetacoplan; this event did not lead to study discontinuation</a:t>
            </a:r>
          </a:p>
          <a:p>
            <a:pPr marL="0" marR="0" lvl="0" indent="0" defTabSz="431963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30000" noProof="0" dirty="0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  </a:t>
            </a:r>
            <a:r>
              <a: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chemeClr val="tx2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Observed infections included nasopharyngitis, urinary tract infection, viral infection, gastrointestinal infection, tonsillitis, vulvovaginal mycotic infection </a:t>
            </a:r>
          </a:p>
        </p:txBody>
      </p: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FC2BF06D-82CA-4452-B76D-4797545CC4E6}"/>
              </a:ext>
            </a:extLst>
          </p:cNvPr>
          <p:cNvGrpSpPr/>
          <p:nvPr/>
        </p:nvGrpSpPr>
        <p:grpSpPr>
          <a:xfrm rot="16200000">
            <a:off x="14021616" y="18210983"/>
            <a:ext cx="2286001" cy="916032"/>
            <a:chOff x="14274500" y="14554105"/>
            <a:chExt cx="2286001" cy="916032"/>
          </a:xfrm>
        </p:grpSpPr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5AD48AEA-8EA6-1E83-E5F4-2CF7E0640A06}"/>
                </a:ext>
              </a:extLst>
            </p:cNvPr>
            <p:cNvSpPr txBox="1"/>
            <p:nvPr/>
          </p:nvSpPr>
          <p:spPr>
            <a:xfrm>
              <a:off x="14274500" y="15070027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8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6A2F9F16-FAE4-0A10-8EB0-612586AE42D4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INCE</a:t>
              </a:r>
            </a:p>
          </p:txBody>
        </p:sp>
      </p:grpSp>
      <p:grpSp>
        <p:nvGrpSpPr>
          <p:cNvPr id="149" name="Group 148">
            <a:extLst>
              <a:ext uri="{FF2B5EF4-FFF2-40B4-BE49-F238E27FC236}">
                <a16:creationId xmlns:a16="http://schemas.microsoft.com/office/drawing/2014/main" id="{1AE2805A-4B43-777A-3291-8CAEE3F3EB2D}"/>
              </a:ext>
            </a:extLst>
          </p:cNvPr>
          <p:cNvGrpSpPr/>
          <p:nvPr/>
        </p:nvGrpSpPr>
        <p:grpSpPr>
          <a:xfrm rot="16200000">
            <a:off x="14021616" y="16458384"/>
            <a:ext cx="2286001" cy="916033"/>
            <a:chOff x="14274500" y="14554105"/>
            <a:chExt cx="2286001" cy="916033"/>
          </a:xfrm>
        </p:grpSpPr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933DF13C-0E36-8B9B-47AE-1487A0B37234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3987E30F-5B84-712D-ABA0-A62AA9098303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ADDOCK</a:t>
              </a:r>
            </a:p>
          </p:txBody>
        </p:sp>
      </p:grpSp>
      <p:grpSp>
        <p:nvGrpSpPr>
          <p:cNvPr id="152" name="Group 151">
            <a:extLst>
              <a:ext uri="{FF2B5EF4-FFF2-40B4-BE49-F238E27FC236}">
                <a16:creationId xmlns:a16="http://schemas.microsoft.com/office/drawing/2014/main" id="{D7F3E43B-2715-EF2E-EB27-D89EF52EF7A2}"/>
              </a:ext>
            </a:extLst>
          </p:cNvPr>
          <p:cNvGrpSpPr/>
          <p:nvPr/>
        </p:nvGrpSpPr>
        <p:grpSpPr>
          <a:xfrm rot="16200000">
            <a:off x="14021616" y="14705785"/>
            <a:ext cx="2286001" cy="916033"/>
            <a:chOff x="14274500" y="14554105"/>
            <a:chExt cx="2286001" cy="916033"/>
          </a:xfrm>
        </p:grpSpPr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9DB39BF9-81CA-E48B-D653-5A41979292DA}"/>
                </a:ext>
              </a:extLst>
            </p:cNvPr>
            <p:cNvSpPr txBox="1"/>
            <p:nvPr/>
          </p:nvSpPr>
          <p:spPr>
            <a:xfrm>
              <a:off x="14274500" y="15070028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3449D7CE-4519-B47C-AA51-72C96C52855B}"/>
                </a:ext>
              </a:extLst>
            </p:cNvPr>
            <p:cNvSpPr txBox="1"/>
            <p:nvPr/>
          </p:nvSpPr>
          <p:spPr>
            <a:xfrm>
              <a:off x="14274501" y="14554105"/>
              <a:ext cx="228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31963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GASUS</a:t>
              </a:r>
            </a:p>
          </p:txBody>
        </p:sp>
      </p:grpSp>
      <p:sp>
        <p:nvSpPr>
          <p:cNvPr id="72" name="Rectangle 71">
            <a:extLst>
              <a:ext uri="{FF2B5EF4-FFF2-40B4-BE49-F238E27FC236}">
                <a16:creationId xmlns:a16="http://schemas.microsoft.com/office/drawing/2014/main" id="{28A10039-90E6-257B-138E-BC9494654B86}"/>
              </a:ext>
            </a:extLst>
          </p:cNvPr>
          <p:cNvSpPr/>
          <p:nvPr/>
        </p:nvSpPr>
        <p:spPr>
          <a:xfrm>
            <a:off x="14630399" y="6629400"/>
            <a:ext cx="8961120" cy="640080"/>
          </a:xfrm>
          <a:prstGeom prst="rect">
            <a:avLst/>
          </a:prstGeom>
          <a:solidFill>
            <a:srgbClr val="6099B0"/>
          </a:solidFill>
          <a:ln>
            <a:solidFill>
              <a:srgbClr val="005D8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aseline Population &amp; Characteristic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A9987B2-236F-C80A-DB37-A6B1A27C3BC5}"/>
              </a:ext>
            </a:extLst>
          </p:cNvPr>
          <p:cNvSpPr txBox="1"/>
          <p:nvPr/>
        </p:nvSpPr>
        <p:spPr>
          <a:xfrm>
            <a:off x="35737800" y="12343412"/>
            <a:ext cx="6583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(%) with Normalized FACIT-Fatigue</a:t>
            </a:r>
          </a:p>
        </p:txBody>
      </p:sp>
      <p:graphicFrame>
        <p:nvGraphicFramePr>
          <p:cNvPr id="83" name="Chart 82">
            <a:extLst>
              <a:ext uri="{FF2B5EF4-FFF2-40B4-BE49-F238E27FC236}">
                <a16:creationId xmlns:a16="http://schemas.microsoft.com/office/drawing/2014/main" id="{72399939-6675-EA06-6772-A70FEF39258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38836393"/>
              </p:ext>
            </p:extLst>
          </p:nvPr>
        </p:nvGraphicFramePr>
        <p:xfrm>
          <a:off x="15544800" y="14371320"/>
          <a:ext cx="7863840" cy="6126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4" name="Rounded Rectangle 14">
            <a:extLst>
              <a:ext uri="{FF2B5EF4-FFF2-40B4-BE49-F238E27FC236}">
                <a16:creationId xmlns:a16="http://schemas.microsoft.com/office/drawing/2014/main" id="{7BFF39F5-2F32-DC1F-71DC-B6A0B259FBCC}"/>
              </a:ext>
            </a:extLst>
          </p:cNvPr>
          <p:cNvSpPr/>
          <p:nvPr/>
        </p:nvSpPr>
        <p:spPr>
          <a:xfrm>
            <a:off x="546420" y="11482581"/>
            <a:ext cx="13106400" cy="1623882"/>
          </a:xfrm>
          <a:prstGeom prst="roundRect">
            <a:avLst/>
          </a:prstGeom>
          <a:solidFill>
            <a:srgbClr val="2C5E76"/>
          </a:solidFill>
          <a:ln>
            <a:solidFill>
              <a:srgbClr val="6099B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457200" indent="-457200" defTabSz="844700">
              <a:spcBef>
                <a:spcPts val="200"/>
              </a:spcBef>
              <a:buFont typeface="Wingdings" panose="05000000000000000000" pitchFamily="2" charset="2"/>
              <a:buChar char="Ø"/>
            </a:pPr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most patients with PNH who had less severe anemia, elevated markers of hemolysis (ARC and LDH) were normalized after pegcetacoplan treatment, regardless of prior complement inhibitor treatment</a:t>
            </a:r>
          </a:p>
        </p:txBody>
      </p:sp>
      <p:sp>
        <p:nvSpPr>
          <p:cNvPr id="86" name="Rounded Rectangle 14">
            <a:extLst>
              <a:ext uri="{FF2B5EF4-FFF2-40B4-BE49-F238E27FC236}">
                <a16:creationId xmlns:a16="http://schemas.microsoft.com/office/drawing/2014/main" id="{E41D3753-B1CD-3467-E2AE-9F1A7648F036}"/>
              </a:ext>
            </a:extLst>
          </p:cNvPr>
          <p:cNvSpPr/>
          <p:nvPr/>
        </p:nvSpPr>
        <p:spPr>
          <a:xfrm>
            <a:off x="546420" y="13216425"/>
            <a:ext cx="13106400" cy="727915"/>
          </a:xfrm>
          <a:prstGeom prst="roundRect">
            <a:avLst/>
          </a:prstGeom>
          <a:solidFill>
            <a:srgbClr val="2C5E76"/>
          </a:solidFill>
          <a:ln>
            <a:solidFill>
              <a:srgbClr val="6099B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457200" indent="-457200" defTabSz="844700">
              <a:spcBef>
                <a:spcPts val="200"/>
              </a:spcBef>
              <a:buFont typeface="Wingdings" panose="05000000000000000000" pitchFamily="2" charset="2"/>
              <a:buChar char="Ø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Pegcetacoplan treatment resulted in clinically improved fatigue score</a:t>
            </a:r>
          </a:p>
        </p:txBody>
      </p:sp>
      <p:sp>
        <p:nvSpPr>
          <p:cNvPr id="87" name="Rounded Rectangle 14">
            <a:extLst>
              <a:ext uri="{FF2B5EF4-FFF2-40B4-BE49-F238E27FC236}">
                <a16:creationId xmlns:a16="http://schemas.microsoft.com/office/drawing/2014/main" id="{2E193C53-7225-B6CB-0343-98627A55D990}"/>
              </a:ext>
            </a:extLst>
          </p:cNvPr>
          <p:cNvSpPr/>
          <p:nvPr/>
        </p:nvSpPr>
        <p:spPr>
          <a:xfrm>
            <a:off x="546420" y="14054301"/>
            <a:ext cx="13106400" cy="1038645"/>
          </a:xfrm>
          <a:prstGeom prst="roundRect">
            <a:avLst/>
          </a:prstGeom>
          <a:solidFill>
            <a:srgbClr val="2C5E76"/>
          </a:solidFill>
          <a:ln>
            <a:solidFill>
              <a:srgbClr val="6099B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457200" indent="-457200" defTabSz="844700">
              <a:spcBef>
                <a:spcPts val="200"/>
              </a:spcBef>
              <a:buFont typeface="Wingdings" panose="05000000000000000000" pitchFamily="2" charset="2"/>
              <a:buChar char="Ø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The safety profile of pegcetacoplan was consistent with previously reported results</a:t>
            </a:r>
            <a:r>
              <a:rPr lang="en-US" sz="2800" baseline="30000" dirty="0">
                <a:latin typeface="Arial" panose="020B0604020202020204" pitchFamily="34" charset="0"/>
                <a:cs typeface="Arial" panose="020B0604020202020204" pitchFamily="34" charset="0"/>
              </a:rPr>
              <a:t>3,</a:t>
            </a:r>
            <a:r>
              <a:rPr lang="en-US" sz="2800" baseline="300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,7,8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4987AF9-1422-8F9A-6B19-99E3B9BBCCCB}"/>
              </a:ext>
            </a:extLst>
          </p:cNvPr>
          <p:cNvSpPr/>
          <p:nvPr/>
        </p:nvSpPr>
        <p:spPr>
          <a:xfrm>
            <a:off x="24094440" y="6629400"/>
            <a:ext cx="8961120" cy="6675120"/>
          </a:xfrm>
          <a:prstGeom prst="rect">
            <a:avLst/>
          </a:prstGeom>
          <a:noFill/>
          <a:ln>
            <a:solidFill>
              <a:srgbClr val="FF9E6D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4337" dirty="0">
              <a:solidFill>
                <a:schemeClr val="tx1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AED9B293-8BD8-A322-665D-7FF4C769BD65}"/>
              </a:ext>
            </a:extLst>
          </p:cNvPr>
          <p:cNvSpPr/>
          <p:nvPr/>
        </p:nvSpPr>
        <p:spPr>
          <a:xfrm>
            <a:off x="24094440" y="6629400"/>
            <a:ext cx="8961120" cy="640080"/>
          </a:xfrm>
          <a:prstGeom prst="rect">
            <a:avLst/>
          </a:prstGeom>
          <a:solidFill>
            <a:srgbClr val="6099B0"/>
          </a:solidFill>
          <a:ln>
            <a:solidFill>
              <a:srgbClr val="005D8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LDH Normalization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A627BBA-AEEB-4144-4825-28616250F5EB}"/>
              </a:ext>
            </a:extLst>
          </p:cNvPr>
          <p:cNvSpPr txBox="1"/>
          <p:nvPr/>
        </p:nvSpPr>
        <p:spPr>
          <a:xfrm>
            <a:off x="16389417" y="19868655"/>
            <a:ext cx="7315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tx1">
                    <a:lumMod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(%) with Gender-specific Normalized Hb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2D10E8B-A246-5EB3-4330-BBBA148FC020}"/>
              </a:ext>
            </a:extLst>
          </p:cNvPr>
          <p:cNvSpPr/>
          <p:nvPr/>
        </p:nvSpPr>
        <p:spPr>
          <a:xfrm>
            <a:off x="14630399" y="13639800"/>
            <a:ext cx="8961120" cy="6675120"/>
          </a:xfrm>
          <a:prstGeom prst="rect">
            <a:avLst/>
          </a:prstGeom>
          <a:noFill/>
          <a:ln>
            <a:solidFill>
              <a:srgbClr val="FF9E6D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4337" dirty="0">
              <a:solidFill>
                <a:schemeClr val="tx1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D37F289B-4899-C4FC-C435-C16FADAFE66A}"/>
              </a:ext>
            </a:extLst>
          </p:cNvPr>
          <p:cNvSpPr/>
          <p:nvPr/>
        </p:nvSpPr>
        <p:spPr>
          <a:xfrm>
            <a:off x="14630399" y="13639799"/>
            <a:ext cx="8961120" cy="640080"/>
          </a:xfrm>
          <a:prstGeom prst="rect">
            <a:avLst/>
          </a:prstGeom>
          <a:solidFill>
            <a:srgbClr val="6099B0"/>
          </a:solidFill>
          <a:ln>
            <a:solidFill>
              <a:srgbClr val="005D8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3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globin Normalization</a:t>
            </a:r>
          </a:p>
        </p:txBody>
      </p:sp>
      <p:pic>
        <p:nvPicPr>
          <p:cNvPr id="8" name="Picture 7" descr="Qr code&#10;&#10;Description automatically generated">
            <a:extLst>
              <a:ext uri="{FF2B5EF4-FFF2-40B4-BE49-F238E27FC236}">
                <a16:creationId xmlns:a16="http://schemas.microsoft.com/office/drawing/2014/main" id="{0BFA430B-FD82-C049-858F-47444DBEC60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18746" y="16840200"/>
            <a:ext cx="182880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1642716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Custom 1">
      <a:dk1>
        <a:srgbClr val="EFF1F0"/>
      </a:dk1>
      <a:lt1>
        <a:srgbClr val="FFFFFF"/>
      </a:lt1>
      <a:dk2>
        <a:srgbClr val="2B5D76"/>
      </a:dk2>
      <a:lt2>
        <a:srgbClr val="5F99AF"/>
      </a:lt2>
      <a:accent1>
        <a:srgbClr val="B6DDE1"/>
      </a:accent1>
      <a:accent2>
        <a:srgbClr val="EC9200"/>
      </a:accent2>
      <a:accent3>
        <a:srgbClr val="FBB714"/>
      </a:accent3>
      <a:accent4>
        <a:srgbClr val="AA3A11"/>
      </a:accent4>
      <a:accent5>
        <a:srgbClr val="E25023"/>
      </a:accent5>
      <a:accent6>
        <a:srgbClr val="E9836D"/>
      </a:accent6>
      <a:hlink>
        <a:srgbClr val="F1BAB4"/>
      </a:hlink>
      <a:folHlink>
        <a:srgbClr val="000000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1" id="{F7ECCB05-6DB3-0C4D-9042-5971CE5954AD}" vid="{3F68DAF3-42F6-9543-AA9B-B38D59A9FED8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1DDA7E8F157E743B902383EB5236960" ma:contentTypeVersion="18" ma:contentTypeDescription="Create a new document." ma:contentTypeScope="" ma:versionID="58ef2690d49ac0f721a17eba06faa6bc">
  <xsd:schema xmlns:xsd="http://www.w3.org/2001/XMLSchema" xmlns:xs="http://www.w3.org/2001/XMLSchema" xmlns:p="http://schemas.microsoft.com/office/2006/metadata/properties" xmlns:ns2="5932064e-040c-41ef-a3b7-6ddd5940dc82" xmlns:ns3="7127645d-ceb2-48b0-ab7d-2452cd852dd2" targetNamespace="http://schemas.microsoft.com/office/2006/metadata/properties" ma:root="true" ma:fieldsID="9cf3bc6dc96e6aca73227bc7a4ac7e6b" ns2:_="" ns3:_="">
    <xsd:import namespace="5932064e-040c-41ef-a3b7-6ddd5940dc82"/>
    <xsd:import namespace="7127645d-ceb2-48b0-ab7d-2452cd852dd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3:SharedWithUsers" minOccurs="0"/>
                <xsd:element ref="ns3:SharedWithDetails" minOccurs="0"/>
                <xsd:element ref="ns2:DateTim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932064e-040c-41ef-a3b7-6ddd5940dc8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DateTime" ma:index="19" nillable="true" ma:displayName="Date &amp; Time" ma:format="DateTime" ma:internalName="DateTime">
      <xsd:simpleType>
        <xsd:restriction base="dms:DateTime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5e65b880-47b9-40fd-8a89-121c3681de5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127645d-ceb2-48b0-ab7d-2452cd852dd2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dbaf2691-4a72-4de0-b409-5250094091e5}" ma:internalName="TaxCatchAll" ma:showField="CatchAllData" ma:web="7127645d-ceb2-48b0-ab7d-2452cd852dd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5932064e-040c-41ef-a3b7-6ddd5940dc82">
      <Terms xmlns="http://schemas.microsoft.com/office/infopath/2007/PartnerControls"/>
    </lcf76f155ced4ddcb4097134ff3c332f>
    <DateTime xmlns="5932064e-040c-41ef-a3b7-6ddd5940dc82" xsi:nil="true"/>
    <TaxCatchAll xmlns="7127645d-ceb2-48b0-ab7d-2452cd852dd2" xsi:nil="true"/>
  </documentManagement>
</p:properties>
</file>

<file path=customXml/itemProps1.xml><?xml version="1.0" encoding="utf-8"?>
<ds:datastoreItem xmlns:ds="http://schemas.openxmlformats.org/officeDocument/2006/customXml" ds:itemID="{19B7B0D2-1855-4625-B942-479F9C1E4E8B}"/>
</file>

<file path=customXml/itemProps2.xml><?xml version="1.0" encoding="utf-8"?>
<ds:datastoreItem xmlns:ds="http://schemas.openxmlformats.org/officeDocument/2006/customXml" ds:itemID="{9FB34B1F-DB95-49E2-BA53-0F5150D38988}"/>
</file>

<file path=customXml/itemProps3.xml><?xml version="1.0" encoding="utf-8"?>
<ds:datastoreItem xmlns:ds="http://schemas.openxmlformats.org/officeDocument/2006/customXml" ds:itemID="{06B0038C-95E9-4C95-A375-F3EC8C658A48}"/>
</file>

<file path=docProps/app.xml><?xml version="1.0" encoding="utf-8"?>
<Properties xmlns="http://schemas.openxmlformats.org/officeDocument/2006/extended-properties" xmlns:vt="http://schemas.openxmlformats.org/officeDocument/2006/docPropsVTypes">
  <Template>Theme1</Template>
  <TotalTime>12524</TotalTime>
  <Words>1563</Words>
  <Application>Microsoft Office PowerPoint</Application>
  <PresentationFormat>Custom</PresentationFormat>
  <Paragraphs>10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Wingdings</vt:lpstr>
      <vt:lpstr>Theme1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cey Fine</dc:creator>
  <cp:lastModifiedBy>Carrie Bray</cp:lastModifiedBy>
  <cp:revision>97</cp:revision>
  <dcterms:created xsi:type="dcterms:W3CDTF">2022-06-15T13:18:46Z</dcterms:created>
  <dcterms:modified xsi:type="dcterms:W3CDTF">2023-10-27T16:11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1DDA7E8F157E743B902383EB5236960</vt:lpwstr>
  </property>
</Properties>
</file>